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389" r:id="rId2"/>
    <p:sldId id="413" r:id="rId3"/>
    <p:sldId id="398" r:id="rId4"/>
    <p:sldId id="414" r:id="rId5"/>
    <p:sldId id="400" r:id="rId6"/>
    <p:sldId id="405" r:id="rId7"/>
    <p:sldId id="406" r:id="rId8"/>
    <p:sldId id="409" r:id="rId9"/>
    <p:sldId id="410" r:id="rId10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8F8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794" autoAdjust="0"/>
    <p:restoredTop sz="92940" autoAdjust="0"/>
  </p:normalViewPr>
  <p:slideViewPr>
    <p:cSldViewPr snapToGrid="0">
      <p:cViewPr>
        <p:scale>
          <a:sx n="100" d="100"/>
          <a:sy n="100" d="100"/>
        </p:scale>
        <p:origin x="-4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51C123-9055-4026-A714-3B7133BAA2DF}" type="datetimeFigureOut">
              <a:rPr kumimoji="1" lang="ja-JP" altLang="en-US" smtClean="0"/>
              <a:t>2026/3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AD3451-D5E3-4CA9-8153-D2133BDE4C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74801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EFB816-F5C4-4BFD-85B3-1831D999F32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29952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0560D23-08FC-299D-38D0-CB5513A6C28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051683D1-7534-781D-DAED-756A755D515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9872A770-DCEE-CAE3-1F9B-CAF569F3714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C9DAC6C-5C75-A5B6-844E-F6FFECFF7EB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EFB816-F5C4-4BFD-85B3-1831D999F328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82803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E643329-9256-4F7F-4EF6-AF556CE3A7A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D2F21BF1-1D5E-F67A-F04A-91D60D3F7F4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3BEE0457-5E55-C14D-3B05-4C7F61AD9D4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3892264-8119-96A4-6795-6E76BE533BE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AD3451-D5E3-4CA9-8153-D2133BDE4C50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338327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AD3451-D5E3-4CA9-8153-D2133BDE4C50}" type="slidenum">
              <a:rPr kumimoji="1" lang="ja-JP" altLang="en-US" smtClean="0"/>
              <a:t>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45284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3792B8-4C9D-30BD-DC47-A663785E5D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9D791AA-7F9C-B826-9819-874F2BC0A2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C2C512C-7381-FE32-3529-126BF99B9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90D6D-7541-487F-8C24-54F0F4CA499A}" type="datetimeFigureOut">
              <a:rPr kumimoji="1" lang="ja-JP" altLang="en-US" smtClean="0"/>
              <a:t>2026/3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DB55A2-0AB1-FC16-B2FB-7C2CF1428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6D8A489-1433-9BFB-4380-70849165C3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C60C4-48EF-4124-A722-E6F87E06B1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3848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DC1057-5BF4-B443-6732-9A79E148F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8FF7EBD-11FE-DCC5-1A2B-62467B9A85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FFCEC7A-DED5-06EC-6559-A5F23B0A5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90D6D-7541-487F-8C24-54F0F4CA499A}" type="datetimeFigureOut">
              <a:rPr kumimoji="1" lang="ja-JP" altLang="en-US" smtClean="0"/>
              <a:t>2026/3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BFBD9E4-3686-562A-09A3-0B2D3D292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26112C-3A10-42C4-8FE3-F51F05A92C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C60C4-48EF-4124-A722-E6F87E06B1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5365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6F98392-8AA2-F86E-DA4C-89D4FC57B7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4B5A223-EA8C-0E03-1488-C2975A578C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5A8CE3D-1AA3-356F-B819-9091B09DC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90D6D-7541-487F-8C24-54F0F4CA499A}" type="datetimeFigureOut">
              <a:rPr kumimoji="1" lang="ja-JP" altLang="en-US" smtClean="0"/>
              <a:t>2026/3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045FD2-8EBB-D837-9A92-DD1525A93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891DEDB-7A5B-84A8-FDC1-7281C6B85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C60C4-48EF-4124-A722-E6F87E06B1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865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0724EB8-DD74-0852-CECC-FB02285096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D1D36BE-66F1-DC80-1704-F840A63F3E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CFC93FD-420C-EE53-BA3D-C279145E6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90D6D-7541-487F-8C24-54F0F4CA499A}" type="datetimeFigureOut">
              <a:rPr kumimoji="1" lang="ja-JP" altLang="en-US" smtClean="0"/>
              <a:t>2026/3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2FD5EA7-BB63-7A07-A8F1-8109F735E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A5FE7F7-21A1-F6BB-07F3-1925979D5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C60C4-48EF-4124-A722-E6F87E06B1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6934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06D6C3-5E2C-81CC-40EB-B566146322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A4884CC-EA73-2985-E674-13B1C5C097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F266AD6-91DB-A83D-9089-553F88D57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90D6D-7541-487F-8C24-54F0F4CA499A}" type="datetimeFigureOut">
              <a:rPr kumimoji="1" lang="ja-JP" altLang="en-US" smtClean="0"/>
              <a:t>2026/3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B62A4C5-C6D8-A231-E1E7-B898751C7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5E7EB4-5BE3-8EF1-BEFD-0E1CF32AE6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C60C4-48EF-4124-A722-E6F87E06B1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0913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94B7D0-5AAB-0AE8-1933-A96E5A3936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19D96CA-E594-4DD0-24BA-AAF5EE9FD7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C1A8B96-D82F-B476-E208-59346A5D04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201C5E-76BE-5324-5CCA-395F10E7B9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90D6D-7541-487F-8C24-54F0F4CA499A}" type="datetimeFigureOut">
              <a:rPr kumimoji="1" lang="ja-JP" altLang="en-US" smtClean="0"/>
              <a:t>2026/3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84CD63A-34E2-56B7-9F85-315B3F4A9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5A49AF6-54C3-2191-55E8-0656FBF78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C60C4-48EF-4124-A722-E6F87E06B1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7592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264B355-F322-6DA5-00AB-480814413E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9DEB633-60A7-29B5-C83F-370BBD5021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D293AD8-689E-DB0D-22DC-224CF65D3C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705FAD8-02F5-1C95-DD33-8CDED3CAC7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AA98A2B-B29F-DB8A-7086-88695D9BDBF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0B145D2-0155-3BDF-3345-E5FBC7CDF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90D6D-7541-487F-8C24-54F0F4CA499A}" type="datetimeFigureOut">
              <a:rPr kumimoji="1" lang="ja-JP" altLang="en-US" smtClean="0"/>
              <a:t>2026/3/1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99E7207-7879-F590-1682-4C579F5C50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93546DE-E21D-235A-5DD4-D734F9760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C60C4-48EF-4124-A722-E6F87E06B1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2706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8818EF-4A19-3A30-0038-DDB737D9F5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AAA537E-2A8A-3922-AF1F-AD4830C4A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90D6D-7541-487F-8C24-54F0F4CA499A}" type="datetimeFigureOut">
              <a:rPr kumimoji="1" lang="ja-JP" altLang="en-US" smtClean="0"/>
              <a:t>2026/3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4F2BE12-3B6C-3276-960F-DB16F50BB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2B4E57F-C825-DFD9-0116-FFD60D6EB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C60C4-48EF-4124-A722-E6F87E06B1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7432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BE054EA-B080-6364-E59D-B15F385A8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90D6D-7541-487F-8C24-54F0F4CA499A}" type="datetimeFigureOut">
              <a:rPr kumimoji="1" lang="ja-JP" altLang="en-US" smtClean="0"/>
              <a:t>2026/3/1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22FF8CD-A86C-4C33-5931-DAEF8CD18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FD824BA-1E2E-0DD7-416A-CCBDC63FE0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C60C4-48EF-4124-A722-E6F87E06B1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6756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5535ED-46BB-0635-98FC-15E6F30E93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985B866-02C6-AF42-4880-2F28334BE2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0D3CB46-0F02-1FE3-C5E5-6E47ED4895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7AAE504-32A3-BC83-8DE9-97994CBAFD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90D6D-7541-487F-8C24-54F0F4CA499A}" type="datetimeFigureOut">
              <a:rPr kumimoji="1" lang="ja-JP" altLang="en-US" smtClean="0"/>
              <a:t>2026/3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F896201-F7A8-47AC-6876-94D17FA20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E75A4DA-769C-32AE-6637-232CF5960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C60C4-48EF-4124-A722-E6F87E06B1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9559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94DB32-7071-EE81-B711-458C8DEECE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01BBF1B-1E83-32C4-E06D-87126929EB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77C0CF2-9B3F-553E-AF0D-DC91CAE6DC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2BC4682-A17F-5493-DCEC-96CDEC74D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90D6D-7541-487F-8C24-54F0F4CA499A}" type="datetimeFigureOut">
              <a:rPr kumimoji="1" lang="ja-JP" altLang="en-US" smtClean="0"/>
              <a:t>2026/3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87CA7DD-816E-AFB6-80E4-F448593F9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73C35C5-7A99-1D51-E93C-1A977C5E6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C60C4-48EF-4124-A722-E6F87E06B1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130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A6ED035-EA60-E1E0-449F-B948A44291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D43DAEA-91C3-A754-AAFF-04E7837060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D06DCA7-3A45-0448-08FB-5B232C3733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B90D6D-7541-487F-8C24-54F0F4CA499A}" type="datetimeFigureOut">
              <a:rPr kumimoji="1" lang="ja-JP" altLang="en-US" smtClean="0"/>
              <a:t>2026/3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D33084-44C4-CFFF-7FD3-3640613F76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903D64-45AB-25A7-8768-2FB20B5AA1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1C60C4-48EF-4124-A722-E6F87E06B1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9907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BB3580CB-461A-AAF9-5F40-0A24813BC87D}"/>
              </a:ext>
            </a:extLst>
          </p:cNvPr>
          <p:cNvGrpSpPr/>
          <p:nvPr/>
        </p:nvGrpSpPr>
        <p:grpSpPr>
          <a:xfrm>
            <a:off x="464281" y="1179150"/>
            <a:ext cx="9987598" cy="4721947"/>
            <a:chOff x="395434" y="1324316"/>
            <a:chExt cx="9987598" cy="4721947"/>
          </a:xfrm>
        </p:grpSpPr>
        <p:cxnSp>
          <p:nvCxnSpPr>
            <p:cNvPr id="32" name="直線矢印コネクタ 31">
              <a:extLst>
                <a:ext uri="{FF2B5EF4-FFF2-40B4-BE49-F238E27FC236}">
                  <a16:creationId xmlns:a16="http://schemas.microsoft.com/office/drawing/2014/main" id="{5A32C20E-19B6-72C7-29D9-6FF9456AF6EC}"/>
                </a:ext>
              </a:extLst>
            </p:cNvPr>
            <p:cNvCxnSpPr>
              <a:cxnSpLocks/>
            </p:cNvCxnSpPr>
            <p:nvPr/>
          </p:nvCxnSpPr>
          <p:spPr>
            <a:xfrm>
              <a:off x="6104945" y="2185562"/>
              <a:ext cx="46959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7B8EF80B-2D4C-2713-4CC1-F1F9D2C92E3A}"/>
                </a:ext>
              </a:extLst>
            </p:cNvPr>
            <p:cNvGrpSpPr/>
            <p:nvPr/>
          </p:nvGrpSpPr>
          <p:grpSpPr>
            <a:xfrm>
              <a:off x="395434" y="1324316"/>
              <a:ext cx="9987598" cy="4721947"/>
              <a:chOff x="395434" y="1366381"/>
              <a:chExt cx="9987598" cy="4721947"/>
            </a:xfrm>
          </p:grpSpPr>
          <p:cxnSp>
            <p:nvCxnSpPr>
              <p:cNvPr id="72" name="直線矢印コネクタ 71">
                <a:extLst>
                  <a:ext uri="{FF2B5EF4-FFF2-40B4-BE49-F238E27FC236}">
                    <a16:creationId xmlns:a16="http://schemas.microsoft.com/office/drawing/2014/main" id="{977A396A-2387-ACB7-9B5A-64C2EE47EB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29085" y="5747722"/>
                <a:ext cx="467099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1" name="グループ化 20">
                <a:extLst>
                  <a:ext uri="{FF2B5EF4-FFF2-40B4-BE49-F238E27FC236}">
                    <a16:creationId xmlns:a16="http://schemas.microsoft.com/office/drawing/2014/main" id="{B877F97E-34C4-0D74-C159-DFFA03DA372A}"/>
                  </a:ext>
                </a:extLst>
              </p:cNvPr>
              <p:cNvGrpSpPr/>
              <p:nvPr/>
            </p:nvGrpSpPr>
            <p:grpSpPr>
              <a:xfrm>
                <a:off x="395434" y="1366381"/>
                <a:ext cx="9987598" cy="4721947"/>
                <a:chOff x="175861" y="717795"/>
                <a:chExt cx="9987598" cy="4721947"/>
              </a:xfrm>
            </p:grpSpPr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4F4B1972-2870-AD22-FD50-84FB751D49EA}"/>
                    </a:ext>
                  </a:extLst>
                </p:cNvPr>
                <p:cNvSpPr txBox="1"/>
                <p:nvPr/>
              </p:nvSpPr>
              <p:spPr>
                <a:xfrm>
                  <a:off x="6361733" y="2541445"/>
                  <a:ext cx="1481588" cy="276999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eoadjuvant therapy</a:t>
                  </a:r>
                </a:p>
              </p:txBody>
            </p:sp>
            <p:grpSp>
              <p:nvGrpSpPr>
                <p:cNvPr id="20" name="グループ化 19">
                  <a:extLst>
                    <a:ext uri="{FF2B5EF4-FFF2-40B4-BE49-F238E27FC236}">
                      <a16:creationId xmlns:a16="http://schemas.microsoft.com/office/drawing/2014/main" id="{92D5BD0B-5C03-23AD-7601-1A93BC442DB0}"/>
                    </a:ext>
                  </a:extLst>
                </p:cNvPr>
                <p:cNvGrpSpPr/>
                <p:nvPr/>
              </p:nvGrpSpPr>
              <p:grpSpPr>
                <a:xfrm>
                  <a:off x="175861" y="717795"/>
                  <a:ext cx="9987598" cy="4721947"/>
                  <a:chOff x="186494" y="717795"/>
                  <a:chExt cx="9987598" cy="4721947"/>
                </a:xfrm>
              </p:grpSpPr>
              <p:cxnSp>
                <p:nvCxnSpPr>
                  <p:cNvPr id="40" name="直線矢印コネクタ 39">
                    <a:extLst>
                      <a:ext uri="{FF2B5EF4-FFF2-40B4-BE49-F238E27FC236}">
                        <a16:creationId xmlns:a16="http://schemas.microsoft.com/office/drawing/2014/main" id="{41DC9E48-6AFE-2E57-48E8-CBB10A45225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149584" y="2679944"/>
                    <a:ext cx="232227" cy="0"/>
                  </a:xfrm>
                  <a:prstGeom prst="straightConnector1">
                    <a:avLst/>
                  </a:prstGeom>
                  <a:ln w="12700">
                    <a:tailEnd type="triangle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9" name="グループ化 18">
                    <a:extLst>
                      <a:ext uri="{FF2B5EF4-FFF2-40B4-BE49-F238E27FC236}">
                        <a16:creationId xmlns:a16="http://schemas.microsoft.com/office/drawing/2014/main" id="{E56E08DD-71E5-89A3-255A-2A300F7D425A}"/>
                      </a:ext>
                    </a:extLst>
                  </p:cNvPr>
                  <p:cNvGrpSpPr/>
                  <p:nvPr/>
                </p:nvGrpSpPr>
                <p:grpSpPr>
                  <a:xfrm>
                    <a:off x="186494" y="717795"/>
                    <a:ext cx="9987598" cy="4721947"/>
                    <a:chOff x="186494" y="685898"/>
                    <a:chExt cx="9987598" cy="4721947"/>
                  </a:xfrm>
                </p:grpSpPr>
                <p:cxnSp>
                  <p:nvCxnSpPr>
                    <p:cNvPr id="12" name="直線矢印コネクタ 11">
                      <a:extLst>
                        <a:ext uri="{FF2B5EF4-FFF2-40B4-BE49-F238E27FC236}">
                          <a16:creationId xmlns:a16="http://schemas.microsoft.com/office/drawing/2014/main" id="{4A003DE7-D95B-690F-445D-AF2CD75CBD5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80076" y="1557109"/>
                      <a:ext cx="222782" cy="0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8" name="グループ化 17">
                      <a:extLst>
                        <a:ext uri="{FF2B5EF4-FFF2-40B4-BE49-F238E27FC236}">
                          <a16:creationId xmlns:a16="http://schemas.microsoft.com/office/drawing/2014/main" id="{3AEBBE47-7FE0-3253-0E14-BCC9BBB71D0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86494" y="685898"/>
                      <a:ext cx="9987598" cy="4721947"/>
                      <a:chOff x="184949" y="693695"/>
                      <a:chExt cx="9987598" cy="4721947"/>
                    </a:xfrm>
                  </p:grpSpPr>
                  <p:cxnSp>
                    <p:nvCxnSpPr>
                      <p:cNvPr id="48" name="直線コネクタ 47">
                        <a:extLst>
                          <a:ext uri="{FF2B5EF4-FFF2-40B4-BE49-F238E27FC236}">
                            <a16:creationId xmlns:a16="http://schemas.microsoft.com/office/drawing/2014/main" id="{7E436186-549B-B6C9-595C-F945F769EBE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V="1">
                        <a:off x="4167763" y="1554941"/>
                        <a:ext cx="10768" cy="1835736"/>
                      </a:xfrm>
                      <a:prstGeom prst="line">
                        <a:avLst/>
                      </a:prstGeom>
                      <a:ln w="12700"/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7" name="直線矢印コネクタ 66">
                        <a:extLst>
                          <a:ext uri="{FF2B5EF4-FFF2-40B4-BE49-F238E27FC236}">
                            <a16:creationId xmlns:a16="http://schemas.microsoft.com/office/drawing/2014/main" id="{3A873653-FACE-D558-5A4E-827D51A51FD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178531" y="2655844"/>
                        <a:ext cx="222782" cy="0"/>
                      </a:xfrm>
                      <a:prstGeom prst="straightConnector1">
                        <a:avLst/>
                      </a:prstGeom>
                      <a:ln w="12700">
                        <a:tailEnd type="triangle"/>
                      </a:ln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9" name="グループ化 8">
                        <a:extLst>
                          <a:ext uri="{FF2B5EF4-FFF2-40B4-BE49-F238E27FC236}">
                            <a16:creationId xmlns:a16="http://schemas.microsoft.com/office/drawing/2014/main" id="{DA5B18CB-6D45-F66D-3D8D-71D249999FF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84949" y="693695"/>
                        <a:ext cx="9987598" cy="4721947"/>
                        <a:chOff x="200189" y="708935"/>
                        <a:chExt cx="9987598" cy="4721947"/>
                      </a:xfrm>
                    </p:grpSpPr>
                    <p:sp>
                      <p:nvSpPr>
                        <p:cNvPr id="3" name="テキスト ボックス 2">
                          <a:extLst>
                            <a:ext uri="{FF2B5EF4-FFF2-40B4-BE49-F238E27FC236}">
                              <a16:creationId xmlns:a16="http://schemas.microsoft.com/office/drawing/2014/main" id="{8AB2EEF5-2A60-F3F3-5B8E-B4F53DA4D6F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14333" y="708935"/>
                          <a:ext cx="2572212" cy="276999"/>
                        </a:xfrm>
                        <a:prstGeom prst="rect">
                          <a:avLst/>
                        </a:prstGeom>
                        <a:noFill/>
                        <a:ln w="12700">
                          <a:solidFill>
                            <a:schemeClr val="tx1"/>
                          </a:solidFill>
                        </a:ln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atients with suspected breast cancer</a:t>
                          </a:r>
                        </a:p>
                      </p:txBody>
                    </p:sp>
                    <p:cxnSp>
                      <p:nvCxnSpPr>
                        <p:cNvPr id="11" name="直線矢印コネクタ 10">
                          <a:extLst>
                            <a:ext uri="{FF2B5EF4-FFF2-40B4-BE49-F238E27FC236}">
                              <a16:creationId xmlns:a16="http://schemas.microsoft.com/office/drawing/2014/main" id="{44AF7FCF-2383-6B25-24BA-EE0393103C1D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1311833" y="993939"/>
                          <a:ext cx="0" cy="211763"/>
                        </a:xfrm>
                        <a:prstGeom prst="straightConnector1">
                          <a:avLst/>
                        </a:prstGeom>
                        <a:ln w="12700">
                          <a:tailEnd type="triangle"/>
                        </a:ln>
                      </p:spPr>
                      <p:style>
                        <a:lnRef idx="2">
                          <a:schemeClr val="dk1"/>
                        </a:lnRef>
                        <a:fillRef idx="0">
                          <a:schemeClr val="dk1"/>
                        </a:fillRef>
                        <a:effectRef idx="1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3" name="テキスト ボックス 22">
                          <a:extLst>
                            <a:ext uri="{FF2B5EF4-FFF2-40B4-BE49-F238E27FC236}">
                              <a16:creationId xmlns:a16="http://schemas.microsoft.com/office/drawing/2014/main" id="{5850240B-819E-197E-0350-DFEC910FBBC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416553" y="2440253"/>
                          <a:ext cx="1746726" cy="461665"/>
                        </a:xfrm>
                        <a:prstGeom prst="rect">
                          <a:avLst/>
                        </a:prstGeom>
                        <a:noFill/>
                        <a:ln w="12700">
                          <a:solidFill>
                            <a:schemeClr val="tx1"/>
                          </a:solidFill>
                        </a:ln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oadjuvant therapy  group</a:t>
                          </a:r>
                          <a:endParaRPr kumimoji="1" lang="en-US" altLang="ja-JP" sz="12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27" name="テキスト ボックス 26">
                          <a:extLst>
                            <a:ext uri="{FF2B5EF4-FFF2-40B4-BE49-F238E27FC236}">
                              <a16:creationId xmlns:a16="http://schemas.microsoft.com/office/drawing/2014/main" id="{685B1ED4-D3E6-8FBB-F022-94D40A8EF33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379290" y="2968009"/>
                          <a:ext cx="3808494" cy="830997"/>
                        </a:xfrm>
                        <a:prstGeom prst="rect">
                          <a:avLst/>
                        </a:prstGeom>
                        <a:noFill/>
                        <a:ln w="12700">
                          <a:solidFill>
                            <a:schemeClr val="tx1"/>
                          </a:solidFill>
                        </a:ln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kumimoji="1" lang="ja-JP" altLang="en-US" sz="1200" u="sng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･</a:t>
                          </a:r>
                          <a:r>
                            <a:rPr kumimoji="1" lang="en-US" altLang="ja-JP" sz="1200" u="sng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ET scan (</a:t>
                          </a:r>
                          <a:r>
                            <a:rPr kumimoji="1" lang="en-US" altLang="ja-JP" sz="1200" u="sng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wbPET</a:t>
                          </a:r>
                          <a:r>
                            <a:rPr kumimoji="1" lang="en-US" altLang="ja-JP" sz="1200" u="sng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, </a:t>
                          </a:r>
                          <a:r>
                            <a:rPr kumimoji="1" lang="en-US" altLang="ja-JP" sz="1200" u="sng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bPET</a:t>
                          </a:r>
                          <a:r>
                            <a:rPr kumimoji="1" lang="en-US" altLang="ja-JP" sz="1200" u="sng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)</a:t>
                          </a:r>
                        </a:p>
                        <a:p>
                          <a:r>
                            <a:rPr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       Before or after the end of preoperative chemotherapy</a:t>
                          </a:r>
                          <a:endParaRPr kumimoji="1" lang="en-US" altLang="ja-JP" sz="1200" u="sng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  <a:p>
                          <a:r>
                            <a:rPr kumimoji="1" lang="ja-JP" altLang="en-US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･</a:t>
                          </a:r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ditional inspections</a:t>
                          </a:r>
                          <a:r>
                            <a:rPr lang="ja-JP" altLang="en-US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 </a:t>
                          </a:r>
                          <a:endParaRPr lang="en-US" altLang="ja-JP" sz="12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  <a:p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  (at the discretion of the attending physician)</a:t>
                          </a:r>
                        </a:p>
                      </p:txBody>
                    </p:sp>
                    <p:sp>
                      <p:nvSpPr>
                        <p:cNvPr id="30" name="テキスト ボックス 29">
                          <a:extLst>
                            <a:ext uri="{FF2B5EF4-FFF2-40B4-BE49-F238E27FC236}">
                              <a16:creationId xmlns:a16="http://schemas.microsoft.com/office/drawing/2014/main" id="{DA5DA8A6-8BD7-CE93-B6B8-8ED092A374E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379290" y="1332582"/>
                          <a:ext cx="3808494" cy="461665"/>
                        </a:xfrm>
                        <a:prstGeom prst="rect">
                          <a:avLst/>
                        </a:prstGeom>
                        <a:noFill/>
                        <a:ln w="12700">
                          <a:solidFill>
                            <a:schemeClr val="tx1"/>
                          </a:solidFill>
                        </a:ln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kumimoji="1" lang="ja-JP" altLang="en-US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･</a:t>
                          </a:r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urgical therapy</a:t>
                          </a:r>
                        </a:p>
                        <a:p>
                          <a:r>
                            <a:rPr kumimoji="1" lang="ja-JP" altLang="en-US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･</a:t>
                          </a:r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Histological examination of</a:t>
                          </a:r>
                          <a:r>
                            <a:rPr lang="ja-JP" altLang="en-US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 </a:t>
                          </a:r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urgical specimens</a:t>
                          </a:r>
                        </a:p>
                      </p:txBody>
                    </p:sp>
                    <p:cxnSp>
                      <p:nvCxnSpPr>
                        <p:cNvPr id="43" name="直線矢印コネクタ 42">
                          <a:extLst>
                            <a:ext uri="{FF2B5EF4-FFF2-40B4-BE49-F238E27FC236}">
                              <a16:creationId xmlns:a16="http://schemas.microsoft.com/office/drawing/2014/main" id="{4147B2B2-6FA7-7DA3-CC73-7FBF0E07B73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7057422" y="2818389"/>
                          <a:ext cx="0" cy="140898"/>
                        </a:xfrm>
                        <a:prstGeom prst="straightConnector1">
                          <a:avLst/>
                        </a:prstGeom>
                        <a:ln w="12700">
                          <a:tailEnd type="triangle"/>
                        </a:ln>
                      </p:spPr>
                      <p:style>
                        <a:lnRef idx="2">
                          <a:schemeClr val="dk1"/>
                        </a:lnRef>
                        <a:fillRef idx="0">
                          <a:schemeClr val="dk1"/>
                        </a:fillRef>
                        <a:effectRef idx="1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44" name="直線矢印コネクタ 43">
                          <a:extLst>
                            <a:ext uri="{FF2B5EF4-FFF2-40B4-BE49-F238E27FC236}">
                              <a16:creationId xmlns:a16="http://schemas.microsoft.com/office/drawing/2014/main" id="{10B6CEE0-979C-223D-B179-03FAE5E19DAF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7057422" y="3804252"/>
                          <a:ext cx="0" cy="183548"/>
                        </a:xfrm>
                        <a:prstGeom prst="straightConnector1">
                          <a:avLst/>
                        </a:prstGeom>
                        <a:ln w="12700">
                          <a:tailEnd type="triangle"/>
                        </a:ln>
                      </p:spPr>
                      <p:style>
                        <a:lnRef idx="2">
                          <a:schemeClr val="dk1"/>
                        </a:lnRef>
                        <a:fillRef idx="0">
                          <a:schemeClr val="dk1"/>
                        </a:fillRef>
                        <a:effectRef idx="1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5" name="テキスト ボックス 44">
                          <a:extLst>
                            <a:ext uri="{FF2B5EF4-FFF2-40B4-BE49-F238E27FC236}">
                              <a16:creationId xmlns:a16="http://schemas.microsoft.com/office/drawing/2014/main" id="{DFEBA325-1374-2782-D9FB-1D37EA0B700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379291" y="3983346"/>
                          <a:ext cx="3808496" cy="461665"/>
                        </a:xfrm>
                        <a:prstGeom prst="rect">
                          <a:avLst/>
                        </a:prstGeom>
                        <a:noFill/>
                        <a:ln w="12700">
                          <a:solidFill>
                            <a:schemeClr val="tx1"/>
                          </a:solidFill>
                        </a:ln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kumimoji="1" lang="ja-JP" altLang="en-US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･</a:t>
                          </a:r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urgical therapy</a:t>
                          </a:r>
                        </a:p>
                        <a:p>
                          <a:r>
                            <a:rPr kumimoji="1" lang="ja-JP" altLang="en-US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･</a:t>
                          </a:r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Histological examination of surgical specimens</a:t>
                          </a:r>
                        </a:p>
                      </p:txBody>
                    </p:sp>
                    <p:sp>
                      <p:nvSpPr>
                        <p:cNvPr id="71" name="テキスト ボックス 70">
                          <a:extLst>
                            <a:ext uri="{FF2B5EF4-FFF2-40B4-BE49-F238E27FC236}">
                              <a16:creationId xmlns:a16="http://schemas.microsoft.com/office/drawing/2014/main" id="{6E2DEFFC-AD15-9F46-CA9B-EC69968CFCC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397769" y="4859443"/>
                          <a:ext cx="1746726" cy="461665"/>
                        </a:xfrm>
                        <a:prstGeom prst="rect">
                          <a:avLst/>
                        </a:prstGeom>
                        <a:ln w="12700"/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ostoperative follow-up group</a:t>
                          </a:r>
                        </a:p>
                      </p:txBody>
                    </p:sp>
                    <p:sp>
                      <p:nvSpPr>
                        <p:cNvPr id="2" name="テキスト ボックス 1">
                          <a:extLst>
                            <a:ext uri="{FF2B5EF4-FFF2-40B4-BE49-F238E27FC236}">
                              <a16:creationId xmlns:a16="http://schemas.microsoft.com/office/drawing/2014/main" id="{3849638B-1991-BE0E-3E9A-3B65797854C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379290" y="4767108"/>
                          <a:ext cx="3808494" cy="646331"/>
                        </a:xfrm>
                        <a:prstGeom prst="rect">
                          <a:avLst/>
                        </a:prstGeom>
                        <a:noFill/>
                        <a:ln w="12700">
                          <a:solidFill>
                            <a:schemeClr val="tx1"/>
                          </a:solidFill>
                        </a:ln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kumimoji="1" lang="ja-JP" altLang="en-US" sz="1200" u="sng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･</a:t>
                          </a:r>
                          <a:r>
                            <a:rPr kumimoji="1" lang="en-US" altLang="ja-JP" sz="1200" u="sng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ET scan (</a:t>
                          </a:r>
                          <a:r>
                            <a:rPr kumimoji="1" lang="en-US" altLang="ja-JP" sz="1200" u="sng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wbPET</a:t>
                          </a:r>
                          <a:r>
                            <a:rPr kumimoji="1" lang="en-US" altLang="ja-JP" sz="1200" u="sng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, </a:t>
                          </a:r>
                          <a:r>
                            <a:rPr kumimoji="1" lang="en-US" altLang="ja-JP" sz="1200" u="sng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bPET</a:t>
                          </a:r>
                          <a:r>
                            <a:rPr kumimoji="1" lang="en-US" altLang="ja-JP" sz="1200" u="sng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)</a:t>
                          </a:r>
                        </a:p>
                        <a:p>
                          <a:r>
                            <a:rPr kumimoji="1" lang="ja-JP" altLang="en-US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･</a:t>
                          </a:r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ditional inspections</a:t>
                          </a:r>
                          <a:r>
                            <a:rPr lang="ja-JP" altLang="en-US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 </a:t>
                          </a:r>
                          <a:endParaRPr lang="en-US" altLang="ja-JP" sz="12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  <a:p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  (at the discretion of the attending physician)</a:t>
                          </a:r>
                        </a:p>
                      </p:txBody>
                    </p:sp>
                    <p:cxnSp>
                      <p:nvCxnSpPr>
                        <p:cNvPr id="10" name="直線矢印コネクタ 9">
                          <a:extLst>
                            <a:ext uri="{FF2B5EF4-FFF2-40B4-BE49-F238E27FC236}">
                              <a16:creationId xmlns:a16="http://schemas.microsoft.com/office/drawing/2014/main" id="{1F33C4E1-A94E-9A54-F497-31738E3EDC8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6144495" y="5090274"/>
                          <a:ext cx="234795" cy="1"/>
                        </a:xfrm>
                        <a:prstGeom prst="straightConnector1">
                          <a:avLst/>
                        </a:prstGeom>
                        <a:ln w="12700">
                          <a:tailEnd type="triangle"/>
                        </a:ln>
                      </p:spPr>
                      <p:style>
                        <a:lnRef idx="2">
                          <a:schemeClr val="dk1"/>
                        </a:lnRef>
                        <a:fillRef idx="0">
                          <a:schemeClr val="dk1"/>
                        </a:fillRef>
                        <a:effectRef idx="1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7" name="左大かっこ 16">
                          <a:extLst>
                            <a:ext uri="{FF2B5EF4-FFF2-40B4-BE49-F238E27FC236}">
                              <a16:creationId xmlns:a16="http://schemas.microsoft.com/office/drawing/2014/main" id="{5E10D298-B1D5-0576-4FD4-0E6AA8EF07C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200189" y="836260"/>
                          <a:ext cx="114144" cy="4271457"/>
                        </a:xfrm>
                        <a:prstGeom prst="leftBracket">
                          <a:avLst/>
                        </a:prstGeom>
                        <a:ln w="12700"/>
                      </p:spPr>
                      <p:style>
                        <a:lnRef idx="2">
                          <a:schemeClr val="dk1"/>
                        </a:lnRef>
                        <a:fillRef idx="0">
                          <a:schemeClr val="dk1"/>
                        </a:fillRef>
                        <a:effectRef idx="1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kumimoji="1" lang="ja-JP" altLang="en-US" dirty="0"/>
                        </a:p>
                      </p:txBody>
                    </p:sp>
                    <p:sp>
                      <p:nvSpPr>
                        <p:cNvPr id="25" name="テキスト ボックス 24">
                          <a:extLst>
                            <a:ext uri="{FF2B5EF4-FFF2-40B4-BE49-F238E27FC236}">
                              <a16:creationId xmlns:a16="http://schemas.microsoft.com/office/drawing/2014/main" id="{3FBB8D4C-9A9A-BACE-8A59-CBD4C413E4C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416553" y="1429017"/>
                          <a:ext cx="1746726" cy="276998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 w="12700">
                          <a:solidFill>
                            <a:schemeClr val="tx1"/>
                          </a:solidFill>
                        </a:ln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rimary care group</a:t>
                          </a:r>
                        </a:p>
                      </p:txBody>
                    </p:sp>
                    <p:grpSp>
                      <p:nvGrpSpPr>
                        <p:cNvPr id="13" name="グループ化 12">
                          <a:extLst>
                            <a:ext uri="{FF2B5EF4-FFF2-40B4-BE49-F238E27FC236}">
                              <a16:creationId xmlns:a16="http://schemas.microsoft.com/office/drawing/2014/main" id="{DA13812C-7DD9-7649-92F0-D9B31AABF00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95106" y="1208220"/>
                          <a:ext cx="3352908" cy="2520863"/>
                          <a:chOff x="323667" y="988487"/>
                          <a:chExt cx="3352908" cy="2520863"/>
                        </a:xfrm>
                      </p:grpSpPr>
                      <p:sp>
                        <p:nvSpPr>
                          <p:cNvPr id="4" name="テキスト ボックス 3">
                            <a:extLst>
                              <a:ext uri="{FF2B5EF4-FFF2-40B4-BE49-F238E27FC236}">
                                <a16:creationId xmlns:a16="http://schemas.microsoft.com/office/drawing/2014/main" id="{6D037996-D5CA-F8C5-1C9A-7B35DC2D4CAA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23667" y="988487"/>
                            <a:ext cx="3338734" cy="461665"/>
                          </a:xfrm>
                          <a:prstGeom prst="rect">
                            <a:avLst/>
                          </a:prstGeom>
                          <a:noFill/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kumimoji="1" lang="ja-JP" altLang="en-US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･</a:t>
                            </a:r>
                            <a:r>
                              <a:rPr kumimoji="1" lang="en-US" altLang="ja-JP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Ultrasonography, mammography examination</a:t>
                            </a:r>
                          </a:p>
                          <a:p>
                            <a:r>
                              <a:rPr kumimoji="1" lang="ja-JP" altLang="en-US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･</a:t>
                            </a:r>
                            <a:r>
                              <a:rPr kumimoji="1" lang="en-US" altLang="ja-JP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Obtain consent for the study</a:t>
                            </a:r>
                          </a:p>
                        </p:txBody>
                      </p:sp>
                      <p:sp>
                        <p:nvSpPr>
                          <p:cNvPr id="5" name="テキスト ボックス 4">
                            <a:extLst>
                              <a:ext uri="{FF2B5EF4-FFF2-40B4-BE49-F238E27FC236}">
                                <a16:creationId xmlns:a16="http://schemas.microsoft.com/office/drawing/2014/main" id="{EB0CAD5A-04D2-FFC4-B24A-A1B5F980EBD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37843" y="2353096"/>
                            <a:ext cx="3338732" cy="276999"/>
                          </a:xfrm>
                          <a:prstGeom prst="rect">
                            <a:avLst/>
                          </a:prstGeom>
                          <a:noFill/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txBody>
                          <a:bodyPr wrap="square" rtlCol="0" anchor="ctr">
                            <a:spAutoFit/>
                          </a:bodyPr>
                          <a:lstStyle/>
                          <a:p>
                            <a:r>
                              <a:rPr kumimoji="1" lang="en-US" altLang="ja-JP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Diagnosis of breast cancer</a:t>
                            </a:r>
                          </a:p>
                        </p:txBody>
                      </p:sp>
                      <p:sp>
                        <p:nvSpPr>
                          <p:cNvPr id="7" name="テキスト ボックス 6">
                            <a:extLst>
                              <a:ext uri="{FF2B5EF4-FFF2-40B4-BE49-F238E27FC236}">
                                <a16:creationId xmlns:a16="http://schemas.microsoft.com/office/drawing/2014/main" id="{10AD64AC-6C0D-18BF-4F50-F5ABBEE0277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30755" y="1673504"/>
                            <a:ext cx="3338734" cy="461665"/>
                          </a:xfrm>
                          <a:prstGeom prst="rect">
                            <a:avLst/>
                          </a:prstGeom>
                          <a:noFill/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kumimoji="1" lang="en-US" altLang="ja-JP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Histological examination of the lesion site </a:t>
                            </a:r>
                          </a:p>
                          <a:p>
                            <a:r>
                              <a:rPr kumimoji="1" lang="ja-JP" altLang="en-US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　</a:t>
                            </a:r>
                            <a:r>
                              <a:rPr kumimoji="1" lang="en-US" altLang="ja-JP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(needle biopsy)</a:t>
                            </a:r>
                          </a:p>
                        </p:txBody>
                      </p:sp>
                      <p:sp>
                        <p:nvSpPr>
                          <p:cNvPr id="8" name="テキスト ボックス 7">
                            <a:extLst>
                              <a:ext uri="{FF2B5EF4-FFF2-40B4-BE49-F238E27FC236}">
                                <a16:creationId xmlns:a16="http://schemas.microsoft.com/office/drawing/2014/main" id="{F8F36DE8-19E3-C4CD-3745-4C663208F557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37843" y="2863019"/>
                            <a:ext cx="3324558" cy="646331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kumimoji="1" lang="ja-JP" altLang="en-US" sz="1200" u="sng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･</a:t>
                            </a:r>
                            <a:r>
                              <a:rPr kumimoji="1" lang="en-US" altLang="ja-JP" sz="1200" u="sng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PET scan (</a:t>
                            </a:r>
                            <a:r>
                              <a:rPr kumimoji="1" lang="en-US" altLang="ja-JP" sz="1200" u="sng" dirty="0" err="1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wb</a:t>
                            </a:r>
                            <a:r>
                              <a:rPr lang="en-US" altLang="ja-JP" sz="1200" u="sng" dirty="0" err="1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PET</a:t>
                            </a:r>
                            <a:r>
                              <a:rPr lang="en-US" altLang="ja-JP" sz="1200" u="sng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, </a:t>
                            </a:r>
                            <a:r>
                              <a:rPr kumimoji="1" lang="en-US" altLang="ja-JP" sz="1200" u="sng" dirty="0" err="1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dbPET</a:t>
                            </a:r>
                            <a:r>
                              <a:rPr kumimoji="1" lang="en-US" altLang="ja-JP" sz="1200" u="sng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)</a:t>
                            </a:r>
                          </a:p>
                          <a:p>
                            <a:r>
                              <a:rPr kumimoji="1" lang="ja-JP" altLang="en-US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･</a:t>
                            </a:r>
                            <a:r>
                              <a:rPr kumimoji="1" lang="en-US" altLang="ja-JP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Additional Inspections</a:t>
                            </a:r>
                            <a:r>
                              <a:rPr lang="ja-JP" altLang="en-US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 </a:t>
                            </a:r>
                            <a:endParaRPr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  <a:p>
                            <a:r>
                              <a:rPr kumimoji="1" lang="en-US" altLang="ja-JP" sz="1200" dirty="0"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     (at the discretion of the attending physician)</a:t>
                            </a:r>
                          </a:p>
                        </p:txBody>
                      </p:sp>
                      <p:cxnSp>
                        <p:nvCxnSpPr>
                          <p:cNvPr id="14" name="直線矢印コネクタ 13">
                            <a:extLst>
                              <a:ext uri="{FF2B5EF4-FFF2-40B4-BE49-F238E27FC236}">
                                <a16:creationId xmlns:a16="http://schemas.microsoft.com/office/drawing/2014/main" id="{5C283126-7E82-B52E-C04B-A820B885E2F9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040394" y="1454801"/>
                            <a:ext cx="0" cy="211763"/>
                          </a:xfrm>
                          <a:prstGeom prst="straightConnector1">
                            <a:avLst/>
                          </a:prstGeom>
                          <a:ln w="12700">
                            <a:tailEnd type="triangle"/>
                          </a:ln>
                        </p:spPr>
                        <p:style>
                          <a:lnRef idx="2">
                            <a:schemeClr val="dk1"/>
                          </a:lnRef>
                          <a:fillRef idx="0">
                            <a:schemeClr val="dk1"/>
                          </a:fillRef>
                          <a:effectRef idx="1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5" name="直線矢印コネクタ 14">
                            <a:extLst>
                              <a:ext uri="{FF2B5EF4-FFF2-40B4-BE49-F238E27FC236}">
                                <a16:creationId xmlns:a16="http://schemas.microsoft.com/office/drawing/2014/main" id="{9847023A-D546-E09A-6B09-125AC6EE6765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040394" y="2139848"/>
                            <a:ext cx="0" cy="211763"/>
                          </a:xfrm>
                          <a:prstGeom prst="straightConnector1">
                            <a:avLst/>
                          </a:prstGeom>
                          <a:ln w="12700">
                            <a:tailEnd type="triangle"/>
                          </a:ln>
                        </p:spPr>
                        <p:style>
                          <a:lnRef idx="2">
                            <a:schemeClr val="dk1"/>
                          </a:lnRef>
                          <a:fillRef idx="0">
                            <a:schemeClr val="dk1"/>
                          </a:fillRef>
                          <a:effectRef idx="1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6" name="直線矢印コネクタ 15">
                            <a:extLst>
                              <a:ext uri="{FF2B5EF4-FFF2-40B4-BE49-F238E27FC236}">
                                <a16:creationId xmlns:a16="http://schemas.microsoft.com/office/drawing/2014/main" id="{796A582E-7F72-240E-3DD5-2D4759D67C24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040394" y="2625640"/>
                            <a:ext cx="0" cy="227828"/>
                          </a:xfrm>
                          <a:prstGeom prst="straightConnector1">
                            <a:avLst/>
                          </a:prstGeom>
                          <a:ln w="12700">
                            <a:tailEnd type="triangle"/>
                          </a:ln>
                        </p:spPr>
                        <p:style>
                          <a:lnRef idx="2">
                            <a:schemeClr val="dk1"/>
                          </a:lnRef>
                          <a:fillRef idx="0">
                            <a:schemeClr val="dk1"/>
                          </a:fillRef>
                          <a:effectRef idx="1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sp>
                      <p:nvSpPr>
                        <p:cNvPr id="28" name="テキスト ボックス 27">
                          <a:extLst>
                            <a:ext uri="{FF2B5EF4-FFF2-40B4-BE49-F238E27FC236}">
                              <a16:creationId xmlns:a16="http://schemas.microsoft.com/office/drawing/2014/main" id="{86181AEB-DAA9-C950-92DF-56B502BFAC3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14333" y="4784551"/>
                          <a:ext cx="3655624" cy="646331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 w="12700">
                          <a:solidFill>
                            <a:schemeClr val="tx1"/>
                          </a:solidFill>
                        </a:ln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atients after breast cancer surgery</a:t>
                          </a:r>
                        </a:p>
                        <a:p>
                          <a:r>
                            <a:rPr kumimoji="1" lang="ja-JP" altLang="en-US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　･</a:t>
                          </a:r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urpose of scrutiny of postoperative recurrence</a:t>
                          </a:r>
                        </a:p>
                        <a:p>
                          <a:r>
                            <a:rPr kumimoji="1" lang="ja-JP" altLang="en-US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　･</a:t>
                          </a:r>
                          <a:r>
                            <a:rPr kumimoji="1" lang="en-US" altLang="ja-JP" sz="12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Obtain consent for the study</a:t>
                          </a:r>
                        </a:p>
                      </p:txBody>
                    </p:sp>
                  </p:grpSp>
                </p:grpSp>
              </p:grpSp>
            </p:grpSp>
          </p:grpSp>
        </p:grpSp>
      </p:grp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CA32DF4-C9AB-DD10-EDE7-6A1E1710E081}"/>
              </a:ext>
            </a:extLst>
          </p:cNvPr>
          <p:cNvSpPr txBox="1"/>
          <p:nvPr/>
        </p:nvSpPr>
        <p:spPr>
          <a:xfrm>
            <a:off x="370126" y="807726"/>
            <a:ext cx="20988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y design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2A7E9E03-DA89-2CAD-BC7F-CE2D736DC61D}"/>
              </a:ext>
            </a:extLst>
          </p:cNvPr>
          <p:cNvCxnSpPr>
            <a:cxnSpLocks/>
            <a:stCxn id="8" idx="3"/>
          </p:cNvCxnSpPr>
          <p:nvPr/>
        </p:nvCxnSpPr>
        <p:spPr>
          <a:xfrm flipV="1">
            <a:off x="4197932" y="3876132"/>
            <a:ext cx="249163" cy="45969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947992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3C0F589-7111-31BC-8354-E95E1A0F41B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F558451B-C1B5-2BA2-EB32-F392461EDB98}"/>
              </a:ext>
            </a:extLst>
          </p:cNvPr>
          <p:cNvCxnSpPr>
            <a:cxnSpLocks/>
          </p:cNvCxnSpPr>
          <p:nvPr/>
        </p:nvCxnSpPr>
        <p:spPr>
          <a:xfrm>
            <a:off x="4231789" y="2565844"/>
            <a:ext cx="860504" cy="0"/>
          </a:xfrm>
          <a:prstGeom prst="straightConnector1">
            <a:avLst/>
          </a:prstGeom>
          <a:ln w="127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DB8BB3E8-9C68-AC5B-B787-B99F1A729F78}"/>
              </a:ext>
            </a:extLst>
          </p:cNvPr>
          <p:cNvCxnSpPr>
            <a:cxnSpLocks/>
          </p:cNvCxnSpPr>
          <p:nvPr/>
        </p:nvCxnSpPr>
        <p:spPr>
          <a:xfrm flipV="1">
            <a:off x="2027229" y="2552291"/>
            <a:ext cx="952011" cy="4596"/>
          </a:xfrm>
          <a:prstGeom prst="straightConnector1">
            <a:avLst/>
          </a:prstGeom>
          <a:ln w="127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741E828E-7EBA-860C-E615-70839451E4B3}"/>
              </a:ext>
            </a:extLst>
          </p:cNvPr>
          <p:cNvGrpSpPr/>
          <p:nvPr/>
        </p:nvGrpSpPr>
        <p:grpSpPr>
          <a:xfrm>
            <a:off x="297067" y="673684"/>
            <a:ext cx="2967624" cy="2065875"/>
            <a:chOff x="91560" y="1155691"/>
            <a:chExt cx="2967624" cy="1630522"/>
          </a:xfrm>
        </p:grpSpPr>
        <p:cxnSp>
          <p:nvCxnSpPr>
            <p:cNvPr id="6" name="直線矢印コネクタ 5">
              <a:extLst>
                <a:ext uri="{FF2B5EF4-FFF2-40B4-BE49-F238E27FC236}">
                  <a16:creationId xmlns:a16="http://schemas.microsoft.com/office/drawing/2014/main" id="{F91C888F-5430-7A85-1157-9AF30524B429}"/>
                </a:ext>
              </a:extLst>
            </p:cNvPr>
            <p:cNvCxnSpPr>
              <a:cxnSpLocks/>
            </p:cNvCxnSpPr>
            <p:nvPr/>
          </p:nvCxnSpPr>
          <p:spPr>
            <a:xfrm>
              <a:off x="636210" y="1505611"/>
              <a:ext cx="0" cy="770476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C8A3F12C-C615-1047-30C4-D7C8C4059611}"/>
                </a:ext>
              </a:extLst>
            </p:cNvPr>
            <p:cNvSpPr txBox="1"/>
            <p:nvPr/>
          </p:nvSpPr>
          <p:spPr>
            <a:xfrm>
              <a:off x="938051" y="1792703"/>
              <a:ext cx="1246864" cy="218626"/>
            </a:xfrm>
            <a:prstGeom prst="rect">
              <a:avLst/>
            </a:prstGeom>
            <a:ln w="1270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 anchor="ctr" anchorCtr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sions n=</a:t>
              </a:r>
              <a:r>
                <a:rPr kumimoji="1" lang="en-US" altLang="ja-JP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cxnSp>
          <p:nvCxnSpPr>
            <p:cNvPr id="10" name="直線矢印コネクタ 9">
              <a:extLst>
                <a:ext uri="{FF2B5EF4-FFF2-40B4-BE49-F238E27FC236}">
                  <a16:creationId xmlns:a16="http://schemas.microsoft.com/office/drawing/2014/main" id="{57F8EF45-FAA7-515F-6D9D-A4A01681DF5B}"/>
                </a:ext>
              </a:extLst>
            </p:cNvPr>
            <p:cNvCxnSpPr>
              <a:cxnSpLocks/>
            </p:cNvCxnSpPr>
            <p:nvPr/>
          </p:nvCxnSpPr>
          <p:spPr>
            <a:xfrm>
              <a:off x="636210" y="1903498"/>
              <a:ext cx="30184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9B3EA04D-DCEE-5FC4-18B9-550449C327F3}"/>
                </a:ext>
              </a:extLst>
            </p:cNvPr>
            <p:cNvSpPr txBox="1"/>
            <p:nvPr/>
          </p:nvSpPr>
          <p:spPr>
            <a:xfrm>
              <a:off x="91560" y="1155691"/>
              <a:ext cx="2967624" cy="364376"/>
            </a:xfrm>
            <a:prstGeom prst="rect">
              <a:avLst/>
            </a:prstGeom>
            <a:ln w="1270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 anchor="ctr" anchorCtr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earch Enrollees 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T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tal </a:t>
              </a:r>
              <a:r>
                <a:rPr kumimoji="1" lang="en-US" altLang="ja-JP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ople)</a:t>
              </a:r>
            </a:p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2020.3</a:t>
              </a:r>
              <a:r>
                <a:rPr kumimoji="1" lang="en-US" altLang="ja-JP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–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23.12) n=21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3247D74F-DD84-BA0F-27CA-E098A3354405}"/>
                </a:ext>
              </a:extLst>
            </p:cNvPr>
            <p:cNvSpPr txBox="1"/>
            <p:nvPr/>
          </p:nvSpPr>
          <p:spPr>
            <a:xfrm>
              <a:off x="98704" y="2276087"/>
              <a:ext cx="2214693" cy="510126"/>
            </a:xfrm>
            <a:prstGeom prst="rect">
              <a:avLst/>
            </a:prstGeom>
            <a:ln w="1270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 anchor="ctr" anchorCtr="0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tal number of </a:t>
              </a:r>
              <a:r>
                <a:rPr kumimoji="1" lang="en-US" altLang="ja-JP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eople included in the</a:t>
              </a:r>
              <a:r>
                <a:rPr lang="ja-JP" alt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</a:t>
              </a:r>
            </a:p>
            <a:p>
              <a:pPr algn="ctr"/>
              <a:r>
                <a:rPr kumimoji="1" lang="en-US" altLang="ja-JP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=204</a:t>
              </a:r>
              <a:endParaRPr kumimoji="1" lang="ja-JP" alt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844AF1-87F4-0A76-7DD0-465A2C3C4058}"/>
              </a:ext>
            </a:extLst>
          </p:cNvPr>
          <p:cNvSpPr txBox="1"/>
          <p:nvPr/>
        </p:nvSpPr>
        <p:spPr>
          <a:xfrm>
            <a:off x="233418" y="293386"/>
            <a:ext cx="3704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2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istered patient allocation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D20A15E1-DB73-1A67-DEC4-009E5F144C49}"/>
              </a:ext>
            </a:extLst>
          </p:cNvPr>
          <p:cNvCxnSpPr>
            <a:cxnSpLocks/>
          </p:cNvCxnSpPr>
          <p:nvPr/>
        </p:nvCxnSpPr>
        <p:spPr>
          <a:xfrm>
            <a:off x="2736469" y="2565844"/>
            <a:ext cx="0" cy="3721771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580DC67-E5B1-8DB7-EA29-87FA65409AFE}"/>
              </a:ext>
            </a:extLst>
          </p:cNvPr>
          <p:cNvSpPr txBox="1"/>
          <p:nvPr/>
        </p:nvSpPr>
        <p:spPr>
          <a:xfrm>
            <a:off x="2962126" y="2428983"/>
            <a:ext cx="1699915" cy="276999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 anchorCtr="0">
            <a:spAutoFit/>
          </a:bodyPr>
          <a:lstStyle/>
          <a:p>
            <a:pPr algn="ctr"/>
            <a:r>
              <a:rPr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mary</a:t>
            </a:r>
            <a:r>
              <a:rPr lang="ja-JP" alt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re group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471CDC7-A38F-0967-F2B0-E5F24D0A6703}"/>
              </a:ext>
            </a:extLst>
          </p:cNvPr>
          <p:cNvSpPr txBox="1"/>
          <p:nvPr/>
        </p:nvSpPr>
        <p:spPr>
          <a:xfrm>
            <a:off x="2962126" y="5292240"/>
            <a:ext cx="1699915" cy="461665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 anchorCtr="0">
            <a:spAutoFit/>
          </a:bodyPr>
          <a:lstStyle/>
          <a:p>
            <a:pPr algn="ctr"/>
            <a:r>
              <a:rPr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oadjuvant therapy</a:t>
            </a:r>
          </a:p>
          <a:p>
            <a:pPr algn="ctr"/>
            <a:r>
              <a:rPr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2FD70FE-078A-B544-BC0A-FA8F1D7BBCB2}"/>
              </a:ext>
            </a:extLst>
          </p:cNvPr>
          <p:cNvSpPr txBox="1"/>
          <p:nvPr/>
        </p:nvSpPr>
        <p:spPr>
          <a:xfrm>
            <a:off x="2979240" y="6083410"/>
            <a:ext cx="1699916" cy="461665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 anchorCtr="0">
            <a:spAutoFit/>
          </a:bodyPr>
          <a:lstStyle/>
          <a:p>
            <a:pPr algn="ctr"/>
            <a:r>
              <a:rPr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stoperative follow-up group </a:t>
            </a:r>
          </a:p>
        </p:txBody>
      </p: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8E869B65-1BB0-68AE-A4CD-6EFF42976F3F}"/>
              </a:ext>
            </a:extLst>
          </p:cNvPr>
          <p:cNvCxnSpPr>
            <a:cxnSpLocks/>
          </p:cNvCxnSpPr>
          <p:nvPr/>
        </p:nvCxnSpPr>
        <p:spPr>
          <a:xfrm>
            <a:off x="2736469" y="5560074"/>
            <a:ext cx="247326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18F0EACC-1F1A-8780-CCDA-82C404EBCB3F}"/>
              </a:ext>
            </a:extLst>
          </p:cNvPr>
          <p:cNvCxnSpPr>
            <a:cxnSpLocks/>
          </p:cNvCxnSpPr>
          <p:nvPr/>
        </p:nvCxnSpPr>
        <p:spPr>
          <a:xfrm>
            <a:off x="2736470" y="6280756"/>
            <a:ext cx="247325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39" name="表 38">
            <a:extLst>
              <a:ext uri="{FF2B5EF4-FFF2-40B4-BE49-F238E27FC236}">
                <a16:creationId xmlns:a16="http://schemas.microsoft.com/office/drawing/2014/main" id="{300929F5-A7D9-DE5B-10C3-6AF7E04BE0F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201241"/>
              </p:ext>
            </p:extLst>
          </p:nvPr>
        </p:nvGraphicFramePr>
        <p:xfrm>
          <a:off x="5105263" y="1559572"/>
          <a:ext cx="3137023" cy="498550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66424">
                  <a:extLst>
                    <a:ext uri="{9D8B030D-6E8A-4147-A177-3AD203B41FA5}">
                      <a16:colId xmlns:a16="http://schemas.microsoft.com/office/drawing/2014/main" val="3743293776"/>
                    </a:ext>
                  </a:extLst>
                </a:gridCol>
                <a:gridCol w="670599">
                  <a:extLst>
                    <a:ext uri="{9D8B030D-6E8A-4147-A177-3AD203B41FA5}">
                      <a16:colId xmlns:a16="http://schemas.microsoft.com/office/drawing/2014/main" val="3070735666"/>
                    </a:ext>
                  </a:extLst>
                </a:gridCol>
              </a:tblGrid>
              <a:tr h="297575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rimary care group</a:t>
                      </a:r>
                      <a:endParaRPr kumimoji="1" lang="ja-JP" altLang="en-US" sz="1200" b="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4875205"/>
                  </a:ext>
                </a:extLst>
              </a:tr>
              <a:tr h="669704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eople enrolled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9352898"/>
                  </a:ext>
                </a:extLst>
              </a:tr>
              <a:tr h="669704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clusion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429337"/>
                  </a:ext>
                </a:extLst>
              </a:tr>
              <a:tr h="66970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number of study subject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0870729"/>
                  </a:ext>
                </a:extLst>
              </a:tr>
              <a:tr h="669704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eople with</a:t>
                      </a:r>
                    </a:p>
                    <a:p>
                      <a:pPr algn="l"/>
                      <a:r>
                        <a:rPr kumimoji="1" lang="fr-FR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kumimoji="1" lang="en-US" altLang="ja-JP" sz="12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ateral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reast lesions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8016178"/>
                  </a:ext>
                </a:extLst>
              </a:tr>
              <a:tr h="669704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eople with </a:t>
                      </a:r>
                    </a:p>
                    <a:p>
                      <a:pPr algn="l"/>
                      <a:r>
                        <a:rPr kumimoji="1" lang="fr-FR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kumimoji="1" lang="en-US" altLang="ja-JP" sz="12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ltiple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esions of the same breast</a:t>
                      </a: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4048018"/>
                  </a:ext>
                </a:extLst>
              </a:tr>
              <a:tr h="66970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Breasts studied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6748729"/>
                  </a:ext>
                </a:extLst>
              </a:tr>
              <a:tr h="66970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Lesions studied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69905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641609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C699FF1C-D646-9E9E-87F2-77993DD472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2136" y="1353877"/>
            <a:ext cx="3824796" cy="3042000"/>
          </a:xfrm>
          <a:prstGeom prst="rect">
            <a:avLst/>
          </a:prstGeom>
        </p:spPr>
      </p:pic>
      <p:pic>
        <p:nvPicPr>
          <p:cNvPr id="11" name="図 10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BCCB8852-EF0A-081A-123C-099FA81B18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77390" y="1353877"/>
            <a:ext cx="3824796" cy="3042000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A1BE22D-4B6F-04FB-1948-C8FF0A280E92}"/>
              </a:ext>
            </a:extLst>
          </p:cNvPr>
          <p:cNvSpPr txBox="1"/>
          <p:nvPr/>
        </p:nvSpPr>
        <p:spPr>
          <a:xfrm>
            <a:off x="1652136" y="4395877"/>
            <a:ext cx="65091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rrelation coefficient ; adjusted R</a:t>
            </a:r>
            <a:r>
              <a:rPr kumimoji="1"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efficient of determination ;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 ;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, body mass index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DA9693E-6151-5053-7FC2-E0809E642A75}"/>
              </a:ext>
            </a:extLst>
          </p:cNvPr>
          <p:cNvSpPr txBox="1"/>
          <p:nvPr/>
        </p:nvSpPr>
        <p:spPr>
          <a:xfrm>
            <a:off x="2112731" y="1429042"/>
            <a:ext cx="2633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.1700-0.0127*Age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0.3663, R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342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B841C9C-2DB8-4F36-1AD9-7A5B79144901}"/>
              </a:ext>
            </a:extLst>
          </p:cNvPr>
          <p:cNvSpPr txBox="1"/>
          <p:nvPr/>
        </p:nvSpPr>
        <p:spPr>
          <a:xfrm>
            <a:off x="5935221" y="1429041"/>
            <a:ext cx="27609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.7289 – 0.0131*BMI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0.1198, R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143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01C5E2F-8E94-AA31-6B94-1D15374C6A05}"/>
              </a:ext>
            </a:extLst>
          </p:cNvPr>
          <p:cNvSpPr txBox="1"/>
          <p:nvPr/>
        </p:nvSpPr>
        <p:spPr>
          <a:xfrm>
            <a:off x="1560512" y="987028"/>
            <a:ext cx="80977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3</a:t>
            </a:r>
            <a:r>
              <a: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healthy mammary site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V max and physical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 (Age, BMI)</a:t>
            </a:r>
          </a:p>
        </p:txBody>
      </p:sp>
    </p:spTree>
    <p:extLst>
      <p:ext uri="{BB962C8B-B14F-4D97-AF65-F5344CB8AC3E}">
        <p14:creationId xmlns:p14="http://schemas.microsoft.com/office/powerpoint/2010/main" val="29356373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D98FEEB-A5C9-7A12-50AC-5EE39ABB01B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446FBEB4-3348-4035-339D-E6F4C89EC6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4816" y="1383639"/>
            <a:ext cx="4151660" cy="3042000"/>
          </a:xfrm>
          <a:prstGeom prst="rect">
            <a:avLst/>
          </a:prstGeom>
        </p:spPr>
      </p:pic>
      <p:pic>
        <p:nvPicPr>
          <p:cNvPr id="61" name="図 60">
            <a:extLst>
              <a:ext uri="{FF2B5EF4-FFF2-40B4-BE49-F238E27FC236}">
                <a16:creationId xmlns:a16="http://schemas.microsoft.com/office/drawing/2014/main" id="{D3B59982-F658-78AA-9225-F71CFDA70D1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03628" y="1383639"/>
            <a:ext cx="3960339" cy="3042000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2290D11-03AA-54BB-BC11-113FB58E2040}"/>
              </a:ext>
            </a:extLst>
          </p:cNvPr>
          <p:cNvSpPr txBox="1"/>
          <p:nvPr/>
        </p:nvSpPr>
        <p:spPr>
          <a:xfrm>
            <a:off x="1236558" y="856967"/>
            <a:ext cx="80984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4</a:t>
            </a:r>
            <a:r>
              <a: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between healthy mammary site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V max,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sical information (menopausal status)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MMG breast density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7598345-0658-5475-189F-17BCD849CDB9}"/>
              </a:ext>
            </a:extLst>
          </p:cNvPr>
          <p:cNvSpPr txBox="1"/>
          <p:nvPr/>
        </p:nvSpPr>
        <p:spPr>
          <a:xfrm>
            <a:off x="1236558" y="4464211"/>
            <a:ext cx="62221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G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mmography examination, * ;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5, ** ;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1, *** ;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01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3" name="グループ化 52">
            <a:extLst>
              <a:ext uri="{FF2B5EF4-FFF2-40B4-BE49-F238E27FC236}">
                <a16:creationId xmlns:a16="http://schemas.microsoft.com/office/drawing/2014/main" id="{A8B6556D-0AF3-7A8A-B926-A53B43056776}"/>
              </a:ext>
            </a:extLst>
          </p:cNvPr>
          <p:cNvGrpSpPr/>
          <p:nvPr/>
        </p:nvGrpSpPr>
        <p:grpSpPr>
          <a:xfrm>
            <a:off x="7063536" y="1828150"/>
            <a:ext cx="885135" cy="276999"/>
            <a:chOff x="7815473" y="1386250"/>
            <a:chExt cx="885135" cy="276999"/>
          </a:xfrm>
        </p:grpSpPr>
        <p:sp>
          <p:nvSpPr>
            <p:cNvPr id="27" name="左大かっこ 26">
              <a:extLst>
                <a:ext uri="{FF2B5EF4-FFF2-40B4-BE49-F238E27FC236}">
                  <a16:creationId xmlns:a16="http://schemas.microsoft.com/office/drawing/2014/main" id="{E5AF7CA2-B31B-E9F4-716F-87DB1E888671}"/>
                </a:ext>
              </a:extLst>
            </p:cNvPr>
            <p:cNvSpPr/>
            <p:nvPr/>
          </p:nvSpPr>
          <p:spPr>
            <a:xfrm rot="5400000">
              <a:off x="8222435" y="1133286"/>
              <a:ext cx="71211" cy="88513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B42BC23F-1FC2-8C35-22B8-6B6B5A1E8784}"/>
                </a:ext>
              </a:extLst>
            </p:cNvPr>
            <p:cNvSpPr txBox="1"/>
            <p:nvPr/>
          </p:nvSpPr>
          <p:spPr>
            <a:xfrm>
              <a:off x="8052583" y="1386250"/>
              <a:ext cx="42885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ja-JP" altLang="en-US" sz="1200" dirty="0"/>
            </a:p>
          </p:txBody>
        </p:sp>
      </p:grp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34B2D847-4BF9-D907-28E1-2297E535A666}"/>
              </a:ext>
            </a:extLst>
          </p:cNvPr>
          <p:cNvGrpSpPr/>
          <p:nvPr/>
        </p:nvGrpSpPr>
        <p:grpSpPr>
          <a:xfrm>
            <a:off x="2634464" y="1642156"/>
            <a:ext cx="1668170" cy="277000"/>
            <a:chOff x="9697163" y="251625"/>
            <a:chExt cx="663999" cy="207321"/>
          </a:xfrm>
        </p:grpSpPr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3280CA98-CF48-97BC-67E3-DC4315D899BD}"/>
                </a:ext>
              </a:extLst>
            </p:cNvPr>
            <p:cNvSpPr txBox="1"/>
            <p:nvPr/>
          </p:nvSpPr>
          <p:spPr>
            <a:xfrm>
              <a:off x="9930391" y="251625"/>
              <a:ext cx="223833" cy="2073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ja-JP" altLang="en-US" sz="1200" dirty="0"/>
            </a:p>
          </p:txBody>
        </p:sp>
        <p:sp>
          <p:nvSpPr>
            <p:cNvPr id="39" name="左大かっこ 38">
              <a:extLst>
                <a:ext uri="{FF2B5EF4-FFF2-40B4-BE49-F238E27FC236}">
                  <a16:creationId xmlns:a16="http://schemas.microsoft.com/office/drawing/2014/main" id="{3D15BDD3-1A0F-37C7-9D5A-3760E62A37A7}"/>
                </a:ext>
              </a:extLst>
            </p:cNvPr>
            <p:cNvSpPr/>
            <p:nvPr/>
          </p:nvSpPr>
          <p:spPr>
            <a:xfrm rot="5400000">
              <a:off x="9990186" y="73398"/>
              <a:ext cx="77954" cy="66399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0597E3BD-4D9D-D0A1-3B33-EBBF5C8C84C1}"/>
              </a:ext>
            </a:extLst>
          </p:cNvPr>
          <p:cNvGrpSpPr/>
          <p:nvPr/>
        </p:nvGrpSpPr>
        <p:grpSpPr>
          <a:xfrm>
            <a:off x="6178158" y="2135535"/>
            <a:ext cx="877735" cy="276999"/>
            <a:chOff x="7815470" y="1413619"/>
            <a:chExt cx="877735" cy="276999"/>
          </a:xfrm>
        </p:grpSpPr>
        <p:sp>
          <p:nvSpPr>
            <p:cNvPr id="55" name="左大かっこ 54">
              <a:extLst>
                <a:ext uri="{FF2B5EF4-FFF2-40B4-BE49-F238E27FC236}">
                  <a16:creationId xmlns:a16="http://schemas.microsoft.com/office/drawing/2014/main" id="{527F3C3B-04B3-09B9-2A4B-4DB54DB481F5}"/>
                </a:ext>
              </a:extLst>
            </p:cNvPr>
            <p:cNvSpPr/>
            <p:nvPr/>
          </p:nvSpPr>
          <p:spPr>
            <a:xfrm rot="5400000">
              <a:off x="8209960" y="1169238"/>
              <a:ext cx="88756" cy="87773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17F4262E-5638-C342-87D1-DF64BA54651A}"/>
                </a:ext>
              </a:extLst>
            </p:cNvPr>
            <p:cNvSpPr txBox="1"/>
            <p:nvPr/>
          </p:nvSpPr>
          <p:spPr>
            <a:xfrm>
              <a:off x="8034509" y="1413619"/>
              <a:ext cx="47261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1200" dirty="0"/>
            </a:p>
          </p:txBody>
        </p:sp>
      </p:grpSp>
      <p:grpSp>
        <p:nvGrpSpPr>
          <p:cNvPr id="57" name="グループ化 56">
            <a:extLst>
              <a:ext uri="{FF2B5EF4-FFF2-40B4-BE49-F238E27FC236}">
                <a16:creationId xmlns:a16="http://schemas.microsoft.com/office/drawing/2014/main" id="{FABE999E-1772-E669-4C9F-794E898A2D0B}"/>
              </a:ext>
            </a:extLst>
          </p:cNvPr>
          <p:cNvGrpSpPr/>
          <p:nvPr/>
        </p:nvGrpSpPr>
        <p:grpSpPr>
          <a:xfrm>
            <a:off x="6178152" y="1651078"/>
            <a:ext cx="1775685" cy="276999"/>
            <a:chOff x="7822389" y="1406459"/>
            <a:chExt cx="896159" cy="287271"/>
          </a:xfrm>
        </p:grpSpPr>
        <p:sp>
          <p:nvSpPr>
            <p:cNvPr id="58" name="左大かっこ 57">
              <a:extLst>
                <a:ext uri="{FF2B5EF4-FFF2-40B4-BE49-F238E27FC236}">
                  <a16:creationId xmlns:a16="http://schemas.microsoft.com/office/drawing/2014/main" id="{B5CEC949-4A3B-1F76-A337-3D7F5BB8AB6B}"/>
                </a:ext>
              </a:extLst>
            </p:cNvPr>
            <p:cNvSpPr/>
            <p:nvPr/>
          </p:nvSpPr>
          <p:spPr>
            <a:xfrm rot="5400000">
              <a:off x="8233543" y="1152575"/>
              <a:ext cx="73852" cy="89615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2F9BED78-5794-5BB8-7677-9FA30E36B0C8}"/>
                </a:ext>
              </a:extLst>
            </p:cNvPr>
            <p:cNvSpPr txBox="1"/>
            <p:nvPr/>
          </p:nvSpPr>
          <p:spPr>
            <a:xfrm>
              <a:off x="8046424" y="1406459"/>
              <a:ext cx="472613" cy="28727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ja-JP" altLang="en-US" sz="1200" dirty="0"/>
            </a:p>
          </p:txBody>
        </p:sp>
      </p:grpSp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id="{83F2DA5A-475F-6607-8493-9B79B051A432}"/>
              </a:ext>
            </a:extLst>
          </p:cNvPr>
          <p:cNvGrpSpPr/>
          <p:nvPr/>
        </p:nvGrpSpPr>
        <p:grpSpPr>
          <a:xfrm>
            <a:off x="6178154" y="1456766"/>
            <a:ext cx="2655897" cy="276999"/>
            <a:chOff x="7824030" y="1399601"/>
            <a:chExt cx="891268" cy="250843"/>
          </a:xfrm>
        </p:grpSpPr>
        <p:sp>
          <p:nvSpPr>
            <p:cNvPr id="65" name="左大かっこ 64">
              <a:extLst>
                <a:ext uri="{FF2B5EF4-FFF2-40B4-BE49-F238E27FC236}">
                  <a16:creationId xmlns:a16="http://schemas.microsoft.com/office/drawing/2014/main" id="{A4C868D5-9338-3127-FDD5-0CDB861AC5A7}"/>
                </a:ext>
              </a:extLst>
            </p:cNvPr>
            <p:cNvSpPr/>
            <p:nvPr/>
          </p:nvSpPr>
          <p:spPr>
            <a:xfrm rot="5400000">
              <a:off x="8237420" y="1126459"/>
              <a:ext cx="64487" cy="891268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1747FFAB-D110-58F7-C682-D5A6CCF2C1CC}"/>
                </a:ext>
              </a:extLst>
            </p:cNvPr>
            <p:cNvSpPr txBox="1"/>
            <p:nvPr/>
          </p:nvSpPr>
          <p:spPr>
            <a:xfrm>
              <a:off x="8190336" y="1399601"/>
              <a:ext cx="130492" cy="25084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4378171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A27D6AB-C3F5-0C91-B14D-17E49DAD9A7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図 45">
            <a:extLst>
              <a:ext uri="{FF2B5EF4-FFF2-40B4-BE49-F238E27FC236}">
                <a16:creationId xmlns:a16="http://schemas.microsoft.com/office/drawing/2014/main" id="{396B617B-7CF9-F183-894E-EBE99F8F72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0867" y="338318"/>
            <a:ext cx="4486695" cy="3042000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CDF659BE-9D58-B8AA-12A7-E84DA1FB19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87029" y="347661"/>
            <a:ext cx="4486695" cy="3042000"/>
          </a:xfrm>
          <a:prstGeom prst="rect">
            <a:avLst/>
          </a:prstGeom>
        </p:spPr>
      </p:pic>
      <p:pic>
        <p:nvPicPr>
          <p:cNvPr id="49" name="図 48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F89CB01D-6A50-A1C4-35D5-3C767F6EF4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10868" y="3147933"/>
            <a:ext cx="4486695" cy="3042000"/>
          </a:xfrm>
          <a:prstGeom prst="rect">
            <a:avLst/>
          </a:prstGeom>
        </p:spPr>
      </p:pic>
      <p:pic>
        <p:nvPicPr>
          <p:cNvPr id="38" name="図 37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1AD10F6B-3A4D-D778-126C-39E9896BD0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95017" y="3147933"/>
            <a:ext cx="4486695" cy="3042000"/>
          </a:xfrm>
          <a:prstGeom prst="rect">
            <a:avLst/>
          </a:prstGeom>
        </p:spPr>
      </p:pic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116AACA0-0965-BCE2-3012-B6EC7DEC4662}"/>
              </a:ext>
            </a:extLst>
          </p:cNvPr>
          <p:cNvSpPr txBox="1"/>
          <p:nvPr/>
        </p:nvSpPr>
        <p:spPr>
          <a:xfrm>
            <a:off x="1690474" y="6189493"/>
            <a:ext cx="91346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H ratio, Lesion sit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Healthy(normal) sit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tio; DCIS, ductal carcinoma in situ; Microinvasive, microinvasive carcinoma; Invasive, invasive carcinoma, * ;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5,  *** ;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01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BC93479-8AB4-3555-F353-2FEEB2034CBD}"/>
              </a:ext>
            </a:extLst>
          </p:cNvPr>
          <p:cNvSpPr txBox="1"/>
          <p:nvPr/>
        </p:nvSpPr>
        <p:spPr>
          <a:xfrm>
            <a:off x="1624485" y="75401"/>
            <a:ext cx="80069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5</a:t>
            </a:r>
            <a:r>
              <a: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between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V 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y(normal) mammary glands, benign findings, and malignant lesions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D0E80933-0581-3D06-0EF5-F764F0C60F6C}"/>
              </a:ext>
            </a:extLst>
          </p:cNvPr>
          <p:cNvGrpSpPr/>
          <p:nvPr/>
        </p:nvGrpSpPr>
        <p:grpSpPr>
          <a:xfrm>
            <a:off x="2870468" y="504383"/>
            <a:ext cx="2573403" cy="276999"/>
            <a:chOff x="9673761" y="220623"/>
            <a:chExt cx="1020462" cy="260572"/>
          </a:xfrm>
        </p:grpSpPr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812B2524-B0EC-70B8-EEAE-0F75845D3039}"/>
                </a:ext>
              </a:extLst>
            </p:cNvPr>
            <p:cNvSpPr txBox="1"/>
            <p:nvPr/>
          </p:nvSpPr>
          <p:spPr>
            <a:xfrm>
              <a:off x="10027178" y="220623"/>
              <a:ext cx="311150" cy="2605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ja-JP" altLang="en-US" sz="1200" dirty="0"/>
            </a:p>
          </p:txBody>
        </p:sp>
        <p:sp>
          <p:nvSpPr>
            <p:cNvPr id="43" name="左大かっこ 42">
              <a:extLst>
                <a:ext uri="{FF2B5EF4-FFF2-40B4-BE49-F238E27FC236}">
                  <a16:creationId xmlns:a16="http://schemas.microsoft.com/office/drawing/2014/main" id="{C2336A65-3F1E-DDF8-8DF0-0BB9B42344B3}"/>
                </a:ext>
              </a:extLst>
            </p:cNvPr>
            <p:cNvSpPr/>
            <p:nvPr/>
          </p:nvSpPr>
          <p:spPr>
            <a:xfrm rot="5400000">
              <a:off x="10155654" y="-109769"/>
              <a:ext cx="56676" cy="102046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D957BF6B-26B1-5515-6EAD-AF1FED11DBEF}"/>
              </a:ext>
            </a:extLst>
          </p:cNvPr>
          <p:cNvGrpSpPr/>
          <p:nvPr/>
        </p:nvGrpSpPr>
        <p:grpSpPr>
          <a:xfrm>
            <a:off x="2870468" y="4735098"/>
            <a:ext cx="1289825" cy="276999"/>
            <a:chOff x="9673761" y="179025"/>
            <a:chExt cx="1289825" cy="276999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AA77A32F-F6A3-CCDD-08F9-F517ED73A419}"/>
                </a:ext>
              </a:extLst>
            </p:cNvPr>
            <p:cNvSpPr txBox="1"/>
            <p:nvPr/>
          </p:nvSpPr>
          <p:spPr>
            <a:xfrm>
              <a:off x="10103535" y="179025"/>
              <a:ext cx="46147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ja-JP" altLang="en-US" sz="1200" dirty="0"/>
            </a:p>
          </p:txBody>
        </p:sp>
        <p:sp>
          <p:nvSpPr>
            <p:cNvPr id="10" name="左大かっこ 9">
              <a:extLst>
                <a:ext uri="{FF2B5EF4-FFF2-40B4-BE49-F238E27FC236}">
                  <a16:creationId xmlns:a16="http://schemas.microsoft.com/office/drawing/2014/main" id="{1A79A9A6-9941-46B0-3141-C087CCF892F9}"/>
                </a:ext>
              </a:extLst>
            </p:cNvPr>
            <p:cNvSpPr/>
            <p:nvPr/>
          </p:nvSpPr>
          <p:spPr>
            <a:xfrm rot="5400000">
              <a:off x="10288549" y="-246236"/>
              <a:ext cx="60249" cy="128982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8D8E1A6E-5305-1969-3382-65700E28E329}"/>
              </a:ext>
            </a:extLst>
          </p:cNvPr>
          <p:cNvGrpSpPr/>
          <p:nvPr/>
        </p:nvGrpSpPr>
        <p:grpSpPr>
          <a:xfrm>
            <a:off x="4197018" y="691058"/>
            <a:ext cx="1246851" cy="276999"/>
            <a:chOff x="9673759" y="211614"/>
            <a:chExt cx="1246851" cy="276999"/>
          </a:xfrm>
        </p:grpSpPr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F90067A8-448B-C517-5BF5-4F800C3C019F}"/>
                </a:ext>
              </a:extLst>
            </p:cNvPr>
            <p:cNvSpPr txBox="1"/>
            <p:nvPr/>
          </p:nvSpPr>
          <p:spPr>
            <a:xfrm>
              <a:off x="10206072" y="211614"/>
              <a:ext cx="31115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1200" dirty="0"/>
            </a:p>
          </p:txBody>
        </p:sp>
        <p:sp>
          <p:nvSpPr>
            <p:cNvPr id="13" name="左大かっこ 12">
              <a:extLst>
                <a:ext uri="{FF2B5EF4-FFF2-40B4-BE49-F238E27FC236}">
                  <a16:creationId xmlns:a16="http://schemas.microsoft.com/office/drawing/2014/main" id="{5FB448CC-0004-6AF2-6742-77F4F71DE5D8}"/>
                </a:ext>
              </a:extLst>
            </p:cNvPr>
            <p:cNvSpPr/>
            <p:nvPr/>
          </p:nvSpPr>
          <p:spPr>
            <a:xfrm rot="5400000">
              <a:off x="10274325" y="-217484"/>
              <a:ext cx="45719" cy="124685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17CDF541-290E-BC58-3EAF-D1258633A386}"/>
              </a:ext>
            </a:extLst>
          </p:cNvPr>
          <p:cNvGrpSpPr/>
          <p:nvPr/>
        </p:nvGrpSpPr>
        <p:grpSpPr>
          <a:xfrm>
            <a:off x="2870468" y="3777733"/>
            <a:ext cx="2573403" cy="276999"/>
            <a:chOff x="9673761" y="220623"/>
            <a:chExt cx="1020462" cy="260572"/>
          </a:xfrm>
        </p:grpSpPr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381F433E-866A-3909-C53B-A9FC904C1025}"/>
                </a:ext>
              </a:extLst>
            </p:cNvPr>
            <p:cNvSpPr txBox="1"/>
            <p:nvPr/>
          </p:nvSpPr>
          <p:spPr>
            <a:xfrm>
              <a:off x="10027178" y="220623"/>
              <a:ext cx="311150" cy="2605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ja-JP" altLang="en-US" sz="1200" dirty="0"/>
            </a:p>
          </p:txBody>
        </p:sp>
        <p:sp>
          <p:nvSpPr>
            <p:cNvPr id="28" name="左大かっこ 27">
              <a:extLst>
                <a:ext uri="{FF2B5EF4-FFF2-40B4-BE49-F238E27FC236}">
                  <a16:creationId xmlns:a16="http://schemas.microsoft.com/office/drawing/2014/main" id="{941AAF5C-84E8-87D9-1BD9-918B874F1850}"/>
                </a:ext>
              </a:extLst>
            </p:cNvPr>
            <p:cNvSpPr/>
            <p:nvPr/>
          </p:nvSpPr>
          <p:spPr>
            <a:xfrm rot="5400000">
              <a:off x="10155654" y="-109769"/>
              <a:ext cx="56676" cy="102046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CC20CCB2-A921-1A37-DD39-98D3417A31AD}"/>
              </a:ext>
            </a:extLst>
          </p:cNvPr>
          <p:cNvGrpSpPr/>
          <p:nvPr/>
        </p:nvGrpSpPr>
        <p:grpSpPr>
          <a:xfrm>
            <a:off x="4154045" y="3994079"/>
            <a:ext cx="1289825" cy="276999"/>
            <a:chOff x="9673760" y="211614"/>
            <a:chExt cx="1289825" cy="276999"/>
          </a:xfrm>
        </p:grpSpPr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A04C8BD2-B594-BB60-48F4-8E53887BB324}"/>
                </a:ext>
              </a:extLst>
            </p:cNvPr>
            <p:cNvSpPr txBox="1"/>
            <p:nvPr/>
          </p:nvSpPr>
          <p:spPr>
            <a:xfrm>
              <a:off x="10206072" y="211614"/>
              <a:ext cx="31115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1200" dirty="0"/>
            </a:p>
          </p:txBody>
        </p:sp>
        <p:sp>
          <p:nvSpPr>
            <p:cNvPr id="35" name="左大かっこ 34">
              <a:extLst>
                <a:ext uri="{FF2B5EF4-FFF2-40B4-BE49-F238E27FC236}">
                  <a16:creationId xmlns:a16="http://schemas.microsoft.com/office/drawing/2014/main" id="{52EF0E59-9CF2-C640-0CD8-FB79DD4D00B1}"/>
                </a:ext>
              </a:extLst>
            </p:cNvPr>
            <p:cNvSpPr/>
            <p:nvPr/>
          </p:nvSpPr>
          <p:spPr>
            <a:xfrm rot="5400000">
              <a:off x="10288548" y="-246236"/>
              <a:ext cx="60249" cy="128982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33124089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7143CE22-5D56-3247-D6B6-892281BAF8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62840" y="295620"/>
            <a:ext cx="3894157" cy="3042000"/>
          </a:xfrm>
          <a:prstGeom prst="rect">
            <a:avLst/>
          </a:prstGeom>
        </p:spPr>
      </p:pic>
      <p:pic>
        <p:nvPicPr>
          <p:cNvPr id="5" name="図 4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708EDDE3-2E5F-B85C-B5BF-49DA2639A4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2436" y="303461"/>
            <a:ext cx="3894156" cy="3042000"/>
          </a:xfrm>
          <a:prstGeom prst="rect">
            <a:avLst/>
          </a:prstGeom>
        </p:spPr>
      </p:pic>
      <p:pic>
        <p:nvPicPr>
          <p:cNvPr id="9" name="図 8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70367BC4-7252-385D-F163-D11D55F91D7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2436" y="3186500"/>
            <a:ext cx="3894156" cy="3042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B76E4B0-466B-45AA-DA53-4F9D874289F0}"/>
              </a:ext>
            </a:extLst>
          </p:cNvPr>
          <p:cNvSpPr txBox="1"/>
          <p:nvPr/>
        </p:nvSpPr>
        <p:spPr>
          <a:xfrm>
            <a:off x="1898017" y="23589"/>
            <a:ext cx="77052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6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E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/H rati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m) and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m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1C0887A-08D5-61BF-D467-211AB3248427}"/>
              </a:ext>
            </a:extLst>
          </p:cNvPr>
          <p:cNvSpPr txBox="1"/>
          <p:nvPr/>
        </p:nvSpPr>
        <p:spPr>
          <a:xfrm>
            <a:off x="2431476" y="364461"/>
            <a:ext cx="2633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3.3889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＋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026*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3776, R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426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6D36526-D8BB-0754-2856-7852EB4018DF}"/>
              </a:ext>
            </a:extLst>
          </p:cNvPr>
          <p:cNvSpPr txBox="1"/>
          <p:nvPr/>
        </p:nvSpPr>
        <p:spPr>
          <a:xfrm>
            <a:off x="2431476" y="3281707"/>
            <a:ext cx="32210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/H ratio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.6507+0.1183*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3276, R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075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266C7BA-5F26-6345-E598-08B817D01AE9}"/>
              </a:ext>
            </a:extLst>
          </p:cNvPr>
          <p:cNvSpPr txBox="1"/>
          <p:nvPr/>
        </p:nvSpPr>
        <p:spPr>
          <a:xfrm>
            <a:off x="1842642" y="6231373"/>
            <a:ext cx="80143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, correlation coefficient; adjusted R</a:t>
            </a:r>
            <a:r>
              <a:rPr kumimoji="1"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efficient of determination,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H ratio, Lesion sit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Healthy(normal) sit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tio ;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linical tumor size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easured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ultrasound, mm) ;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athological tumor size (mm), (n=98, malignant lesion only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図 16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262C2B07-5DA3-F4E4-C75A-F07C1BDFDB9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62840" y="3214757"/>
            <a:ext cx="3894157" cy="3042000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8C7E44E-C9A2-BC85-359A-51DB34E3C66E}"/>
              </a:ext>
            </a:extLst>
          </p:cNvPr>
          <p:cNvSpPr txBox="1"/>
          <p:nvPr/>
        </p:nvSpPr>
        <p:spPr>
          <a:xfrm>
            <a:off x="6518231" y="364461"/>
            <a:ext cx="2633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4.848+0.1391*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3576, R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279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79E1105-E310-8973-4A7E-1461D42194DF}"/>
              </a:ext>
            </a:extLst>
          </p:cNvPr>
          <p:cNvSpPr txBox="1"/>
          <p:nvPr/>
        </p:nvSpPr>
        <p:spPr>
          <a:xfrm>
            <a:off x="6496299" y="3289548"/>
            <a:ext cx="32210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/H ratio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.6507+0.1183*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3155, R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000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</a:t>
            </a:r>
          </a:p>
        </p:txBody>
      </p:sp>
    </p:spTree>
    <p:extLst>
      <p:ext uri="{BB962C8B-B14F-4D97-AF65-F5344CB8AC3E}">
        <p14:creationId xmlns:p14="http://schemas.microsoft.com/office/powerpoint/2010/main" val="29242447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73026A6-50E9-ABD9-6E40-8E8AA05A77A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図 19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40853E98-0A3E-C449-A625-2780789BF0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69418" y="322178"/>
            <a:ext cx="3959043" cy="3042853"/>
          </a:xfrm>
          <a:prstGeom prst="rect">
            <a:avLst/>
          </a:prstGeom>
        </p:spPr>
      </p:pic>
      <p:pic>
        <p:nvPicPr>
          <p:cNvPr id="3" name="図 2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2423EBEE-A48C-BCC4-DD5D-C542A06D02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19193" y="322177"/>
            <a:ext cx="3959042" cy="3042854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0549644-9DE5-B3C1-7259-3FA630692595}"/>
              </a:ext>
            </a:extLst>
          </p:cNvPr>
          <p:cNvSpPr txBox="1"/>
          <p:nvPr/>
        </p:nvSpPr>
        <p:spPr>
          <a:xfrm>
            <a:off x="1743373" y="16352"/>
            <a:ext cx="85981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7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E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/H ratio,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-67(%) and Oncotype DX RS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1FC3AF2-7B40-D9C2-61C9-1A7D222841C1}"/>
              </a:ext>
            </a:extLst>
          </p:cNvPr>
          <p:cNvSpPr txBox="1"/>
          <p:nvPr/>
        </p:nvSpPr>
        <p:spPr>
          <a:xfrm>
            <a:off x="2348789" y="393269"/>
            <a:ext cx="26579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4.657+0.1170*Ki-67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5593, R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313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80976C1-5973-5381-0AA7-D1766AA19916}"/>
              </a:ext>
            </a:extLst>
          </p:cNvPr>
          <p:cNvSpPr txBox="1"/>
          <p:nvPr/>
        </p:nvSpPr>
        <p:spPr>
          <a:xfrm>
            <a:off x="1769954" y="6207549"/>
            <a:ext cx="82811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, correlation coefficient ; adjusted R</a:t>
            </a:r>
            <a:r>
              <a:rPr kumimoji="1"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efficient of determination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;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-67, n=98 (malignant lesion only) ;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H ratio, Lesion sit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Healthy(normal) sit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tio ;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cotype DX RS, Oncotype DX breast recurrence score (n=27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図 9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D4D0AF88-23BA-D9E1-CED2-E4220430E1A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30519" y="3201685"/>
            <a:ext cx="3959043" cy="3042855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576DC5D-BE78-F5FB-2703-3B305120D517}"/>
              </a:ext>
            </a:extLst>
          </p:cNvPr>
          <p:cNvSpPr txBox="1"/>
          <p:nvPr/>
        </p:nvSpPr>
        <p:spPr>
          <a:xfrm>
            <a:off x="2348789" y="3272777"/>
            <a:ext cx="33539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/H ratio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3.5312+0.0647*Ki-67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4687, R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2197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7DBAA85-4081-D433-78E1-8C2A4B343C22}"/>
              </a:ext>
            </a:extLst>
          </p:cNvPr>
          <p:cNvSpPr txBox="1"/>
          <p:nvPr/>
        </p:nvSpPr>
        <p:spPr>
          <a:xfrm>
            <a:off x="6566660" y="379829"/>
            <a:ext cx="34618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5.688+0.0641*Oncotype DX RS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1789, R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320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3719</a:t>
            </a:r>
          </a:p>
        </p:txBody>
      </p:sp>
      <p:pic>
        <p:nvPicPr>
          <p:cNvPr id="25" name="図 24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869D6E69-948B-F4C6-35AA-36B2626C45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69052" y="3225262"/>
            <a:ext cx="3982063" cy="2995699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DD79959-591D-50A8-8AC7-7AE5375A00B4}"/>
              </a:ext>
            </a:extLst>
          </p:cNvPr>
          <p:cNvSpPr txBox="1"/>
          <p:nvPr/>
        </p:nvSpPr>
        <p:spPr>
          <a:xfrm>
            <a:off x="6589314" y="3272777"/>
            <a:ext cx="34618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/H ratio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= 4.0627+0.0307*Oncotype DX RS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0.1163, R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135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5715</a:t>
            </a:r>
          </a:p>
        </p:txBody>
      </p:sp>
    </p:spTree>
    <p:extLst>
      <p:ext uri="{BB962C8B-B14F-4D97-AF65-F5344CB8AC3E}">
        <p14:creationId xmlns:p14="http://schemas.microsoft.com/office/powerpoint/2010/main" val="41806639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図 41">
            <a:extLst>
              <a:ext uri="{FF2B5EF4-FFF2-40B4-BE49-F238E27FC236}">
                <a16:creationId xmlns:a16="http://schemas.microsoft.com/office/drawing/2014/main" id="{66C92846-C735-1BF1-F46D-5B8BB25B38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22291" y="390228"/>
            <a:ext cx="4486695" cy="3042000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007C5831-1FD5-1091-F9B9-A23591457F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80951" y="387000"/>
            <a:ext cx="4486695" cy="3042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B59598A-9F38-6C84-67E2-FC8FC2DBF1EF}"/>
              </a:ext>
            </a:extLst>
          </p:cNvPr>
          <p:cNvSpPr txBox="1"/>
          <p:nvPr/>
        </p:nvSpPr>
        <p:spPr>
          <a:xfrm>
            <a:off x="1980951" y="110001"/>
            <a:ext cx="76415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8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E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/H ratio, nuclear grade and histological grad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図 9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39C22F76-6E96-AFD9-7662-4192B5E8BD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80951" y="3326455"/>
            <a:ext cx="4486695" cy="3042000"/>
          </a:xfrm>
          <a:prstGeom prst="rect">
            <a:avLst/>
          </a:prstGeom>
        </p:spPr>
      </p:pic>
      <p:pic>
        <p:nvPicPr>
          <p:cNvPr id="18" name="図 17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2EE480DF-A33C-51C7-AB36-12DCA24BD17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21814" y="3326455"/>
            <a:ext cx="4486695" cy="3042000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BC073C6-AD80-39D9-A770-B743410A4A1F}"/>
              </a:ext>
            </a:extLst>
          </p:cNvPr>
          <p:cNvSpPr txBox="1"/>
          <p:nvPr/>
        </p:nvSpPr>
        <p:spPr>
          <a:xfrm>
            <a:off x="1980952" y="6368455"/>
            <a:ext cx="91275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N ratio, Lesion sit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Healthy(normal) sit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tio ; NG, nuclear grade ; HG, histological grade ;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;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5, ** ;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1, *** ;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01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E0CB9C35-1290-C1C1-64AC-4B9023F23A9F}"/>
              </a:ext>
            </a:extLst>
          </p:cNvPr>
          <p:cNvGrpSpPr/>
          <p:nvPr/>
        </p:nvGrpSpPr>
        <p:grpSpPr>
          <a:xfrm>
            <a:off x="3139707" y="667349"/>
            <a:ext cx="2593185" cy="276999"/>
            <a:chOff x="9673761" y="184528"/>
            <a:chExt cx="2593185" cy="276999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51D539C4-F602-1618-ADF3-6C1A7AC886F7}"/>
                </a:ext>
              </a:extLst>
            </p:cNvPr>
            <p:cNvSpPr txBox="1"/>
            <p:nvPr/>
          </p:nvSpPr>
          <p:spPr>
            <a:xfrm>
              <a:off x="10717372" y="184528"/>
              <a:ext cx="50596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ja-JP" altLang="en-US" sz="1200" dirty="0"/>
            </a:p>
          </p:txBody>
        </p:sp>
        <p:sp>
          <p:nvSpPr>
            <p:cNvPr id="5" name="左大かっこ 4">
              <a:extLst>
                <a:ext uri="{FF2B5EF4-FFF2-40B4-BE49-F238E27FC236}">
                  <a16:creationId xmlns:a16="http://schemas.microsoft.com/office/drawing/2014/main" id="{3B2A15E6-3204-A925-4E73-162578F1B118}"/>
                </a:ext>
              </a:extLst>
            </p:cNvPr>
            <p:cNvSpPr/>
            <p:nvPr/>
          </p:nvSpPr>
          <p:spPr>
            <a:xfrm rot="5400000">
              <a:off x="10931503" y="-906642"/>
              <a:ext cx="77701" cy="259318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2EAB8C75-ED91-1811-153B-64E3A6F27912}"/>
              </a:ext>
            </a:extLst>
          </p:cNvPr>
          <p:cNvGrpSpPr/>
          <p:nvPr/>
        </p:nvGrpSpPr>
        <p:grpSpPr>
          <a:xfrm>
            <a:off x="3139706" y="3847849"/>
            <a:ext cx="2593187" cy="306655"/>
            <a:chOff x="9673761" y="122146"/>
            <a:chExt cx="2593187" cy="306655"/>
          </a:xfrm>
        </p:grpSpPr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B8F2FC49-0A80-DB38-15E1-D8C48CBF9B67}"/>
                </a:ext>
              </a:extLst>
            </p:cNvPr>
            <p:cNvSpPr txBox="1"/>
            <p:nvPr/>
          </p:nvSpPr>
          <p:spPr>
            <a:xfrm>
              <a:off x="10814777" y="122146"/>
              <a:ext cx="3389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ja-JP" altLang="en-US" sz="1200" dirty="0"/>
            </a:p>
          </p:txBody>
        </p:sp>
        <p:sp>
          <p:nvSpPr>
            <p:cNvPr id="29" name="左大かっこ 28">
              <a:extLst>
                <a:ext uri="{FF2B5EF4-FFF2-40B4-BE49-F238E27FC236}">
                  <a16:creationId xmlns:a16="http://schemas.microsoft.com/office/drawing/2014/main" id="{DEB28DD7-F8CE-BCE2-CCC7-B8460379470B}"/>
                </a:ext>
              </a:extLst>
            </p:cNvPr>
            <p:cNvSpPr/>
            <p:nvPr/>
          </p:nvSpPr>
          <p:spPr>
            <a:xfrm rot="5400000">
              <a:off x="10900313" y="-937834"/>
              <a:ext cx="140083" cy="259318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62EBF054-DBA6-4313-AF69-85E7F6FF700F}"/>
              </a:ext>
            </a:extLst>
          </p:cNvPr>
          <p:cNvGrpSpPr/>
          <p:nvPr/>
        </p:nvGrpSpPr>
        <p:grpSpPr>
          <a:xfrm>
            <a:off x="7826553" y="667349"/>
            <a:ext cx="2534000" cy="276999"/>
            <a:chOff x="9673762" y="199847"/>
            <a:chExt cx="2534000" cy="276999"/>
          </a:xfrm>
        </p:grpSpPr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C861BBB3-3C38-E9E1-57D7-F3AD02B7E621}"/>
                </a:ext>
              </a:extLst>
            </p:cNvPr>
            <p:cNvSpPr txBox="1"/>
            <p:nvPr/>
          </p:nvSpPr>
          <p:spPr>
            <a:xfrm>
              <a:off x="10798656" y="199847"/>
              <a:ext cx="31115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1200" dirty="0"/>
            </a:p>
          </p:txBody>
        </p:sp>
        <p:sp>
          <p:nvSpPr>
            <p:cNvPr id="32" name="左大かっこ 31">
              <a:extLst>
                <a:ext uri="{FF2B5EF4-FFF2-40B4-BE49-F238E27FC236}">
                  <a16:creationId xmlns:a16="http://schemas.microsoft.com/office/drawing/2014/main" id="{19FD9619-0265-FEF5-B840-B8FD25175B55}"/>
                </a:ext>
              </a:extLst>
            </p:cNvPr>
            <p:cNvSpPr/>
            <p:nvPr/>
          </p:nvSpPr>
          <p:spPr>
            <a:xfrm rot="5400000">
              <a:off x="10909571" y="-869389"/>
              <a:ext cx="62381" cy="253400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94420815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図 45">
            <a:extLst>
              <a:ext uri="{FF2B5EF4-FFF2-40B4-BE49-F238E27FC236}">
                <a16:creationId xmlns:a16="http://schemas.microsoft.com/office/drawing/2014/main" id="{EE0C4A85-A3CB-05D9-8974-255ADE6A58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43177" y="356856"/>
            <a:ext cx="4486695" cy="3042000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35936A49-CF74-21F7-5D44-189FA98F95A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61459" y="361354"/>
            <a:ext cx="4486695" cy="3042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EEA5821-0F74-EC1F-4C56-D10447D71C62}"/>
              </a:ext>
            </a:extLst>
          </p:cNvPr>
          <p:cNvSpPr txBox="1"/>
          <p:nvPr/>
        </p:nvSpPr>
        <p:spPr>
          <a:xfrm>
            <a:off x="2061222" y="97495"/>
            <a:ext cx="79124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between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E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/H ratio, MMG category, and US category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図 9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FC069AD1-C564-32A7-3FDE-AC11AB5C03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36988" y="3355154"/>
            <a:ext cx="4486695" cy="3042000"/>
          </a:xfrm>
          <a:prstGeom prst="rect">
            <a:avLst/>
          </a:prstGeom>
        </p:spPr>
      </p:pic>
      <p:pic>
        <p:nvPicPr>
          <p:cNvPr id="18" name="図 17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C9967935-34AD-D7B0-0347-D6FA8F45844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61459" y="3318290"/>
            <a:ext cx="4486695" cy="3042000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52C7DB1-5CA6-E69F-CA8E-068FB959A748}"/>
              </a:ext>
            </a:extLst>
          </p:cNvPr>
          <p:cNvSpPr txBox="1"/>
          <p:nvPr/>
        </p:nvSpPr>
        <p:spPr>
          <a:xfrm>
            <a:off x="2116678" y="6318918"/>
            <a:ext cx="81763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/H ratio, Lesion sit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Healthy(normal) sit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PE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Vma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tio; MMG, mammography; US, ultrasonography ; * ;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5, ** ;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1, *** ;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01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34953A4E-98EE-C8BB-E1F6-2E42BA1941DB}"/>
              </a:ext>
            </a:extLst>
          </p:cNvPr>
          <p:cNvGrpSpPr/>
          <p:nvPr/>
        </p:nvGrpSpPr>
        <p:grpSpPr>
          <a:xfrm>
            <a:off x="3172571" y="682494"/>
            <a:ext cx="2860789" cy="276999"/>
            <a:chOff x="7801755" y="287344"/>
            <a:chExt cx="2860789" cy="276999"/>
          </a:xfrm>
        </p:grpSpPr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23FEB2E6-9E10-C616-A890-047A52EA2128}"/>
                </a:ext>
              </a:extLst>
            </p:cNvPr>
            <p:cNvSpPr txBox="1"/>
            <p:nvPr/>
          </p:nvSpPr>
          <p:spPr>
            <a:xfrm>
              <a:off x="9065485" y="287344"/>
              <a:ext cx="43784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ja-JP" altLang="en-US" sz="1200" dirty="0"/>
            </a:p>
          </p:txBody>
        </p:sp>
        <p:sp>
          <p:nvSpPr>
            <p:cNvPr id="8" name="左大かっこ 7">
              <a:extLst>
                <a:ext uri="{FF2B5EF4-FFF2-40B4-BE49-F238E27FC236}">
                  <a16:creationId xmlns:a16="http://schemas.microsoft.com/office/drawing/2014/main" id="{4547B5EC-093A-B992-D5C1-9594F7E8CF2E}"/>
                </a:ext>
              </a:extLst>
            </p:cNvPr>
            <p:cNvSpPr/>
            <p:nvPr/>
          </p:nvSpPr>
          <p:spPr>
            <a:xfrm rot="5400000">
              <a:off x="9202786" y="-954837"/>
              <a:ext cx="58727" cy="286078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0B78E5CB-CE47-B43E-5E1F-25F589B0C50D}"/>
              </a:ext>
            </a:extLst>
          </p:cNvPr>
          <p:cNvGrpSpPr/>
          <p:nvPr/>
        </p:nvGrpSpPr>
        <p:grpSpPr>
          <a:xfrm>
            <a:off x="8733099" y="523933"/>
            <a:ext cx="1932970" cy="276999"/>
            <a:chOff x="6891491" y="655514"/>
            <a:chExt cx="1932970" cy="276999"/>
          </a:xfrm>
        </p:grpSpPr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8690315E-390A-A224-ECC5-BFB38E4D6E4E}"/>
                </a:ext>
              </a:extLst>
            </p:cNvPr>
            <p:cNvSpPr txBox="1"/>
            <p:nvPr/>
          </p:nvSpPr>
          <p:spPr>
            <a:xfrm>
              <a:off x="7722591" y="655514"/>
              <a:ext cx="31115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1200" dirty="0"/>
            </a:p>
          </p:txBody>
        </p:sp>
        <p:sp>
          <p:nvSpPr>
            <p:cNvPr id="12" name="左大かっこ 11">
              <a:extLst>
                <a:ext uri="{FF2B5EF4-FFF2-40B4-BE49-F238E27FC236}">
                  <a16:creationId xmlns:a16="http://schemas.microsoft.com/office/drawing/2014/main" id="{28B7675F-3333-8A45-136A-55EB5A926DBB}"/>
                </a:ext>
              </a:extLst>
            </p:cNvPr>
            <p:cNvSpPr/>
            <p:nvPr/>
          </p:nvSpPr>
          <p:spPr>
            <a:xfrm rot="5400000">
              <a:off x="7826786" y="-134937"/>
              <a:ext cx="62379" cy="193297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7533F30A-C6BE-3A86-8A18-D9640FDCE7A9}"/>
              </a:ext>
            </a:extLst>
          </p:cNvPr>
          <p:cNvGrpSpPr/>
          <p:nvPr/>
        </p:nvGrpSpPr>
        <p:grpSpPr>
          <a:xfrm>
            <a:off x="9719775" y="730347"/>
            <a:ext cx="946295" cy="276999"/>
            <a:chOff x="9673762" y="226059"/>
            <a:chExt cx="843460" cy="276999"/>
          </a:xfrm>
        </p:grpSpPr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FBF0DC3F-5559-DA23-391F-488A50D3D466}"/>
                </a:ext>
              </a:extLst>
            </p:cNvPr>
            <p:cNvSpPr txBox="1"/>
            <p:nvPr/>
          </p:nvSpPr>
          <p:spPr>
            <a:xfrm>
              <a:off x="9902268" y="226059"/>
              <a:ext cx="38644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ja-JP" altLang="en-US" sz="1200" dirty="0"/>
            </a:p>
          </p:txBody>
        </p:sp>
        <p:sp>
          <p:nvSpPr>
            <p:cNvPr id="16" name="左大かっこ 15">
              <a:extLst>
                <a:ext uri="{FF2B5EF4-FFF2-40B4-BE49-F238E27FC236}">
                  <a16:creationId xmlns:a16="http://schemas.microsoft.com/office/drawing/2014/main" id="{6FA71F15-8D22-1C5A-54AF-1649CC400AD5}"/>
                </a:ext>
              </a:extLst>
            </p:cNvPr>
            <p:cNvSpPr/>
            <p:nvPr/>
          </p:nvSpPr>
          <p:spPr>
            <a:xfrm rot="5400000">
              <a:off x="10064301" y="-24120"/>
              <a:ext cx="62381" cy="84346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9C2427FC-ACBF-F793-6B91-946A958601EC}"/>
              </a:ext>
            </a:extLst>
          </p:cNvPr>
          <p:cNvGrpSpPr/>
          <p:nvPr/>
        </p:nvGrpSpPr>
        <p:grpSpPr>
          <a:xfrm>
            <a:off x="3168145" y="3972148"/>
            <a:ext cx="1911710" cy="260623"/>
            <a:chOff x="7801756" y="13117"/>
            <a:chExt cx="1911710" cy="491805"/>
          </a:xfrm>
        </p:grpSpPr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9DD9C002-FE32-3B45-4238-A2CEC78884BB}"/>
                </a:ext>
              </a:extLst>
            </p:cNvPr>
            <p:cNvSpPr txBox="1"/>
            <p:nvPr/>
          </p:nvSpPr>
          <p:spPr>
            <a:xfrm>
              <a:off x="8598433" y="13117"/>
              <a:ext cx="437847" cy="2769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1200" dirty="0"/>
            </a:p>
          </p:txBody>
        </p:sp>
        <p:sp>
          <p:nvSpPr>
            <p:cNvPr id="28" name="左大かっこ 27">
              <a:extLst>
                <a:ext uri="{FF2B5EF4-FFF2-40B4-BE49-F238E27FC236}">
                  <a16:creationId xmlns:a16="http://schemas.microsoft.com/office/drawing/2014/main" id="{0992DB7D-D838-E078-67B0-A9A21E3CF4F5}"/>
                </a:ext>
              </a:extLst>
            </p:cNvPr>
            <p:cNvSpPr/>
            <p:nvPr/>
          </p:nvSpPr>
          <p:spPr>
            <a:xfrm rot="5400000">
              <a:off x="8665789" y="-542755"/>
              <a:ext cx="183644" cy="191171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B02448E8-1AF9-7631-AEFA-D5A513B199DD}"/>
              </a:ext>
            </a:extLst>
          </p:cNvPr>
          <p:cNvGrpSpPr/>
          <p:nvPr/>
        </p:nvGrpSpPr>
        <p:grpSpPr>
          <a:xfrm>
            <a:off x="3172571" y="4148974"/>
            <a:ext cx="901896" cy="235507"/>
            <a:chOff x="7801756" y="-26044"/>
            <a:chExt cx="901896" cy="530965"/>
          </a:xfrm>
        </p:grpSpPr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23C13A83-907A-EBAB-2572-78813FA8013C}"/>
                </a:ext>
              </a:extLst>
            </p:cNvPr>
            <p:cNvSpPr txBox="1"/>
            <p:nvPr/>
          </p:nvSpPr>
          <p:spPr>
            <a:xfrm>
              <a:off x="8033779" y="-26044"/>
              <a:ext cx="437847" cy="27700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1200" dirty="0"/>
            </a:p>
          </p:txBody>
        </p:sp>
        <p:sp>
          <p:nvSpPr>
            <p:cNvPr id="31" name="左大かっこ 30">
              <a:extLst>
                <a:ext uri="{FF2B5EF4-FFF2-40B4-BE49-F238E27FC236}">
                  <a16:creationId xmlns:a16="http://schemas.microsoft.com/office/drawing/2014/main" id="{D8138E6F-03DF-03FA-791A-ED2C95CC823F}"/>
                </a:ext>
              </a:extLst>
            </p:cNvPr>
            <p:cNvSpPr/>
            <p:nvPr/>
          </p:nvSpPr>
          <p:spPr>
            <a:xfrm rot="5400000">
              <a:off x="8160882" y="-37848"/>
              <a:ext cx="183643" cy="90189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F9580669-C31D-99FC-BDFA-5A84E50EADDE}"/>
              </a:ext>
            </a:extLst>
          </p:cNvPr>
          <p:cNvGrpSpPr/>
          <p:nvPr/>
        </p:nvGrpSpPr>
        <p:grpSpPr>
          <a:xfrm>
            <a:off x="3172571" y="3803653"/>
            <a:ext cx="2860789" cy="433666"/>
            <a:chOff x="7801755" y="343773"/>
            <a:chExt cx="2860789" cy="276999"/>
          </a:xfrm>
        </p:grpSpPr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2DBA1058-3422-4383-4D13-FD7D5F65B17F}"/>
                </a:ext>
              </a:extLst>
            </p:cNvPr>
            <p:cNvSpPr txBox="1"/>
            <p:nvPr/>
          </p:nvSpPr>
          <p:spPr>
            <a:xfrm>
              <a:off x="9078584" y="343773"/>
              <a:ext cx="43784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ja-JP" altLang="en-US" sz="1200" dirty="0"/>
            </a:p>
          </p:txBody>
        </p:sp>
        <p:sp>
          <p:nvSpPr>
            <p:cNvPr id="38" name="左大かっこ 37">
              <a:extLst>
                <a:ext uri="{FF2B5EF4-FFF2-40B4-BE49-F238E27FC236}">
                  <a16:creationId xmlns:a16="http://schemas.microsoft.com/office/drawing/2014/main" id="{0433468F-46F7-D382-6969-7A33F35D04BF}"/>
                </a:ext>
              </a:extLst>
            </p:cNvPr>
            <p:cNvSpPr/>
            <p:nvPr/>
          </p:nvSpPr>
          <p:spPr>
            <a:xfrm rot="5400000">
              <a:off x="9202786" y="-954837"/>
              <a:ext cx="58727" cy="286078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2CC68AB7-F356-3423-3960-7193B5A6C278}"/>
              </a:ext>
            </a:extLst>
          </p:cNvPr>
          <p:cNvGrpSpPr/>
          <p:nvPr/>
        </p:nvGrpSpPr>
        <p:grpSpPr>
          <a:xfrm>
            <a:off x="9703556" y="4020486"/>
            <a:ext cx="946295" cy="276999"/>
            <a:chOff x="9673762" y="226059"/>
            <a:chExt cx="843460" cy="276999"/>
          </a:xfrm>
        </p:grpSpPr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1C9D17B8-1C3B-943F-1A93-023F59E8BB48}"/>
                </a:ext>
              </a:extLst>
            </p:cNvPr>
            <p:cNvSpPr txBox="1"/>
            <p:nvPr/>
          </p:nvSpPr>
          <p:spPr>
            <a:xfrm>
              <a:off x="9902268" y="226059"/>
              <a:ext cx="38644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1200" dirty="0"/>
            </a:p>
          </p:txBody>
        </p:sp>
        <p:sp>
          <p:nvSpPr>
            <p:cNvPr id="41" name="左大かっこ 40">
              <a:extLst>
                <a:ext uri="{FF2B5EF4-FFF2-40B4-BE49-F238E27FC236}">
                  <a16:creationId xmlns:a16="http://schemas.microsoft.com/office/drawing/2014/main" id="{41188C19-32C2-0D7A-5944-D211D91A94CD}"/>
                </a:ext>
              </a:extLst>
            </p:cNvPr>
            <p:cNvSpPr/>
            <p:nvPr/>
          </p:nvSpPr>
          <p:spPr>
            <a:xfrm rot="5400000">
              <a:off x="10064301" y="-24120"/>
              <a:ext cx="62381" cy="84346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A94EE991-B8A5-10A3-EA92-1789ADFAED1C}"/>
              </a:ext>
            </a:extLst>
          </p:cNvPr>
          <p:cNvGrpSpPr/>
          <p:nvPr/>
        </p:nvGrpSpPr>
        <p:grpSpPr>
          <a:xfrm>
            <a:off x="8716880" y="3809591"/>
            <a:ext cx="1932970" cy="276999"/>
            <a:chOff x="6891491" y="655514"/>
            <a:chExt cx="1932970" cy="276999"/>
          </a:xfrm>
        </p:grpSpPr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79862F57-76E6-97B4-4539-CBC8F242663D}"/>
                </a:ext>
              </a:extLst>
            </p:cNvPr>
            <p:cNvSpPr txBox="1"/>
            <p:nvPr/>
          </p:nvSpPr>
          <p:spPr>
            <a:xfrm>
              <a:off x="7722591" y="655514"/>
              <a:ext cx="31115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1200" dirty="0"/>
            </a:p>
          </p:txBody>
        </p:sp>
        <p:sp>
          <p:nvSpPr>
            <p:cNvPr id="44" name="左大かっこ 43">
              <a:extLst>
                <a:ext uri="{FF2B5EF4-FFF2-40B4-BE49-F238E27FC236}">
                  <a16:creationId xmlns:a16="http://schemas.microsoft.com/office/drawing/2014/main" id="{AEABA0EE-A445-B94B-5382-23BCF9E4115A}"/>
                </a:ext>
              </a:extLst>
            </p:cNvPr>
            <p:cNvSpPr/>
            <p:nvPr/>
          </p:nvSpPr>
          <p:spPr>
            <a:xfrm rot="5400000">
              <a:off x="7826786" y="-134937"/>
              <a:ext cx="62379" cy="193297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5394300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92</TotalTime>
  <Words>918</Words>
  <Application>Microsoft Office PowerPoint</Application>
  <PresentationFormat>ワイド画面</PresentationFormat>
  <Paragraphs>117</Paragraphs>
  <Slides>9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9</vt:i4>
      </vt:variant>
    </vt:vector>
  </HeadingPairs>
  <TitlesOfParts>
    <vt:vector size="14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Ocana Noronha</dc:creator>
  <cp:lastModifiedBy>陽子 佐藤</cp:lastModifiedBy>
  <cp:revision>68</cp:revision>
  <dcterms:created xsi:type="dcterms:W3CDTF">2025-04-07T03:30:45Z</dcterms:created>
  <dcterms:modified xsi:type="dcterms:W3CDTF">2026-03-15T09:43:28Z</dcterms:modified>
</cp:coreProperties>
</file>